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5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6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 horzBarState="maximized">
    <p:restoredLeft sz="21302" autoAdjust="0"/>
    <p:restoredTop sz="94660"/>
  </p:normalViewPr>
  <p:slideViewPr>
    <p:cSldViewPr snapToGrid="0">
      <p:cViewPr>
        <p:scale>
          <a:sx n="50" d="100"/>
          <a:sy n="50" d="100"/>
        </p:scale>
        <p:origin x="-1212" y="-534"/>
      </p:cViewPr>
      <p:guideLst>
        <p:guide orient="horz" pos="2160"/>
        <p:guide pos="386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CN" smtClean="0"/>
              <a:t>Click to edit Master subtitle style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ACAC6-6FEA-45A0-8023-3BD0EB4DFF3D}" type="datetimeFigureOut">
              <a:rPr lang="zh-CN" altLang="en-US" smtClean="0"/>
              <a:pPr/>
              <a:t>2018/2/1 Thurs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85ED1-5258-4732-8489-3F97AAE46EA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171095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ACAC6-6FEA-45A0-8023-3BD0EB4DFF3D}" type="datetimeFigureOut">
              <a:rPr lang="zh-CN" altLang="en-US" smtClean="0"/>
              <a:pPr/>
              <a:t>2018/2/1 Thurs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85ED1-5258-4732-8489-3F97AAE46EA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839639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zh-CN" smtClean="0"/>
              <a:t>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ACAC6-6FEA-45A0-8023-3BD0EB4DFF3D}" type="datetimeFigureOut">
              <a:rPr lang="zh-CN" altLang="en-US" smtClean="0"/>
              <a:pPr/>
              <a:t>2018/2/1 Thurs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85ED1-5258-4732-8489-3F97AAE46EA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421422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 smtClean="0"/>
              <a:t>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ACAC6-6FEA-45A0-8023-3BD0EB4DFF3D}" type="datetimeFigureOut">
              <a:rPr lang="zh-CN" altLang="en-US" smtClean="0"/>
              <a:pPr/>
              <a:t>2018/2/1 Thurs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85ED1-5258-4732-8489-3F97AAE46EA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566822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ACAC6-6FEA-45A0-8023-3BD0EB4DFF3D}" type="datetimeFigureOut">
              <a:rPr lang="zh-CN" altLang="en-US" smtClean="0"/>
              <a:pPr/>
              <a:t>2018/2/1 Thurs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85ED1-5258-4732-8489-3F97AAE46EA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1184111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 smtClean="0"/>
              <a:t>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 smtClean="0"/>
              <a:t>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ACAC6-6FEA-45A0-8023-3BD0EB4DFF3D}" type="datetimeFigureOut">
              <a:rPr lang="zh-CN" altLang="en-US" smtClean="0"/>
              <a:pPr/>
              <a:t>2018/2/1 Thursday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85ED1-5258-4732-8489-3F97AAE46EA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0010441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zh-CN" smtClean="0"/>
              <a:t>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zh-CN" smtClean="0"/>
              <a:t>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ACAC6-6FEA-45A0-8023-3BD0EB4DFF3D}" type="datetimeFigureOut">
              <a:rPr lang="zh-CN" altLang="en-US" smtClean="0"/>
              <a:pPr/>
              <a:t>2018/2/1 Thursday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85ED1-5258-4732-8489-3F97AAE46EA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2406708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ACAC6-6FEA-45A0-8023-3BD0EB4DFF3D}" type="datetimeFigureOut">
              <a:rPr lang="zh-CN" altLang="en-US" smtClean="0"/>
              <a:pPr/>
              <a:t>2018/2/1 Thursday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85ED1-5258-4732-8489-3F97AAE46EA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691033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ACAC6-6FEA-45A0-8023-3BD0EB4DFF3D}" type="datetimeFigureOut">
              <a:rPr lang="zh-CN" altLang="en-US" smtClean="0"/>
              <a:pPr/>
              <a:t>2018/2/1 Thursday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85ED1-5258-4732-8489-3F97AAE46EA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781286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 smtClean="0"/>
              <a:t>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ACAC6-6FEA-45A0-8023-3BD0EB4DFF3D}" type="datetimeFigureOut">
              <a:rPr lang="zh-CN" altLang="en-US" smtClean="0"/>
              <a:pPr/>
              <a:t>2018/2/1 Thursday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85ED1-5258-4732-8489-3F97AAE46EA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621838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ACAC6-6FEA-45A0-8023-3BD0EB4DFF3D}" type="datetimeFigureOut">
              <a:rPr lang="zh-CN" altLang="en-US" smtClean="0"/>
              <a:pPr/>
              <a:t>2018/2/1 Thursday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85ED1-5258-4732-8489-3F97AAE46EA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0120033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 smtClean="0"/>
              <a:t>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9ACAC6-6FEA-45A0-8023-3BD0EB4DFF3D}" type="datetimeFigureOut">
              <a:rPr lang="zh-CN" altLang="en-US" smtClean="0"/>
              <a:pPr/>
              <a:t>2018/2/1 Thurs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285ED1-5258-4732-8489-3F97AAE46EA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7538248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80397" y="1086843"/>
            <a:ext cx="3268106" cy="1800493"/>
            <a:chOff x="1609047" y="1000125"/>
            <a:chExt cx="3268106" cy="1800493"/>
          </a:xfrm>
        </p:grpSpPr>
        <p:sp>
          <p:nvSpPr>
            <p:cNvPr id="3" name="TextBox 2"/>
            <p:cNvSpPr txBox="1"/>
            <p:nvPr/>
          </p:nvSpPr>
          <p:spPr>
            <a:xfrm>
              <a:off x="1609047" y="1000125"/>
              <a:ext cx="3268106" cy="1800493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100" b="1" dirty="0" smtClean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Bio-Rep1</a:t>
              </a:r>
            </a:p>
            <a:p>
              <a:endPara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675376" y="2339117"/>
              <a:ext cx="681111" cy="369332"/>
            </a:xfrm>
            <a:prstGeom prst="rect">
              <a:avLst/>
            </a:prstGeom>
            <a:solidFill>
              <a:srgbClr val="00B050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488355" y="2334126"/>
              <a:ext cx="655742" cy="369332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HL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" name="Group 7"/>
            <p:cNvGrpSpPr/>
            <p:nvPr/>
          </p:nvGrpSpPr>
          <p:grpSpPr>
            <a:xfrm>
              <a:off x="1941095" y="2155600"/>
              <a:ext cx="916272" cy="153276"/>
              <a:chOff x="1519251" y="2750034"/>
              <a:chExt cx="7140779" cy="491086"/>
            </a:xfrm>
          </p:grpSpPr>
          <p:cxnSp>
            <p:nvCxnSpPr>
              <p:cNvPr id="9" name="Straight Connector 8"/>
              <p:cNvCxnSpPr/>
              <p:nvPr/>
            </p:nvCxnSpPr>
            <p:spPr>
              <a:xfrm>
                <a:off x="1519251" y="2750034"/>
                <a:ext cx="7126715" cy="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/>
              <p:cNvCxnSpPr/>
              <p:nvPr/>
            </p:nvCxnSpPr>
            <p:spPr>
              <a:xfrm>
                <a:off x="1535141" y="2750526"/>
                <a:ext cx="0" cy="490594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/>
              <p:cNvCxnSpPr/>
              <p:nvPr/>
            </p:nvCxnSpPr>
            <p:spPr>
              <a:xfrm>
                <a:off x="8660030" y="2750034"/>
                <a:ext cx="0" cy="490594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6" name="Group 15"/>
            <p:cNvGrpSpPr/>
            <p:nvPr/>
          </p:nvGrpSpPr>
          <p:grpSpPr>
            <a:xfrm>
              <a:off x="1945710" y="1484372"/>
              <a:ext cx="894523" cy="644824"/>
              <a:chOff x="2040643" y="1186739"/>
              <a:chExt cx="894523" cy="644824"/>
            </a:xfrm>
          </p:grpSpPr>
          <p:sp>
            <p:nvSpPr>
              <p:cNvPr id="17" name="TextBox 16"/>
              <p:cNvSpPr txBox="1"/>
              <p:nvPr/>
            </p:nvSpPr>
            <p:spPr>
              <a:xfrm>
                <a:off x="2040643" y="1186739"/>
                <a:ext cx="89452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lang="zh-CN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8" name="Group 17"/>
              <p:cNvGrpSpPr/>
              <p:nvPr/>
            </p:nvGrpSpPr>
            <p:grpSpPr>
              <a:xfrm>
                <a:off x="2193600" y="1497109"/>
                <a:ext cx="531040" cy="334454"/>
                <a:chOff x="4655928" y="910972"/>
                <a:chExt cx="531040" cy="334454"/>
              </a:xfrm>
            </p:grpSpPr>
            <p:grpSp>
              <p:nvGrpSpPr>
                <p:cNvPr id="19" name="Group 18"/>
                <p:cNvGrpSpPr/>
                <p:nvPr/>
              </p:nvGrpSpPr>
              <p:grpSpPr>
                <a:xfrm>
                  <a:off x="4655928" y="912312"/>
                  <a:ext cx="141343" cy="330765"/>
                  <a:chOff x="4728410" y="1646186"/>
                  <a:chExt cx="348916" cy="808255"/>
                </a:xfrm>
              </p:grpSpPr>
              <p:sp>
                <p:nvSpPr>
                  <p:cNvPr id="34" name="Trapezoid 33"/>
                  <p:cNvSpPr/>
                  <p:nvPr/>
                </p:nvSpPr>
                <p:spPr>
                  <a:xfrm rot="10800000">
                    <a:off x="4728410" y="2129588"/>
                    <a:ext cx="348916" cy="324853"/>
                  </a:xfrm>
                  <a:prstGeom prst="trapezoid">
                    <a:avLst>
                      <a:gd name="adj" fmla="val 26580"/>
                    </a:avLst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" name="Freeform 34"/>
                  <p:cNvSpPr/>
                  <p:nvPr/>
                </p:nvSpPr>
                <p:spPr>
                  <a:xfrm>
                    <a:off x="4860760" y="1708483"/>
                    <a:ext cx="84220" cy="559468"/>
                  </a:xfrm>
                  <a:custGeom>
                    <a:avLst/>
                    <a:gdLst>
                      <a:gd name="connsiteX0" fmla="*/ 36699 w 120921"/>
                      <a:gd name="connsiteY0" fmla="*/ 1022685 h 1022685"/>
                      <a:gd name="connsiteX1" fmla="*/ 72794 w 120921"/>
                      <a:gd name="connsiteY1" fmla="*/ 685800 h 1022685"/>
                      <a:gd name="connsiteX2" fmla="*/ 605 w 120921"/>
                      <a:gd name="connsiteY2" fmla="*/ 288758 h 1022685"/>
                      <a:gd name="connsiteX3" fmla="*/ 120921 w 120921"/>
                      <a:gd name="connsiteY3" fmla="*/ 0 h 102268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20921" h="1022685">
                        <a:moveTo>
                          <a:pt x="36699" y="1022685"/>
                        </a:moveTo>
                        <a:cubicBezTo>
                          <a:pt x="57754" y="915403"/>
                          <a:pt x="78810" y="808121"/>
                          <a:pt x="72794" y="685800"/>
                        </a:cubicBezTo>
                        <a:cubicBezTo>
                          <a:pt x="66778" y="563479"/>
                          <a:pt x="-7416" y="403058"/>
                          <a:pt x="605" y="288758"/>
                        </a:cubicBezTo>
                        <a:cubicBezTo>
                          <a:pt x="8626" y="174458"/>
                          <a:pt x="102874" y="54142"/>
                          <a:pt x="120921" y="0"/>
                        </a:cubicBezTo>
                      </a:path>
                    </a:pathLst>
                  </a:custGeom>
                  <a:noFill/>
                  <a:ln>
                    <a:solidFill>
                      <a:srgbClr val="00B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" name="Oval 35"/>
                  <p:cNvSpPr/>
                  <p:nvPr/>
                </p:nvSpPr>
                <p:spPr>
                  <a:xfrm rot="2661292" flipH="1">
                    <a:off x="4862109" y="1665564"/>
                    <a:ext cx="89204" cy="45719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" name="Oval 36"/>
                  <p:cNvSpPr/>
                  <p:nvPr/>
                </p:nvSpPr>
                <p:spPr>
                  <a:xfrm rot="2060320" flipV="1">
                    <a:off x="4921067" y="1921042"/>
                    <a:ext cx="59461" cy="129716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" name="Oval 37"/>
                  <p:cNvSpPr/>
                  <p:nvPr/>
                </p:nvSpPr>
                <p:spPr>
                  <a:xfrm rot="1383139">
                    <a:off x="4736678" y="1826313"/>
                    <a:ext cx="125950" cy="77157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" name="Oval 38"/>
                  <p:cNvSpPr/>
                  <p:nvPr/>
                </p:nvSpPr>
                <p:spPr>
                  <a:xfrm rot="19895792" flipH="1">
                    <a:off x="4934175" y="1646186"/>
                    <a:ext cx="116962" cy="76970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20" name="Group 19"/>
                <p:cNvGrpSpPr/>
                <p:nvPr/>
              </p:nvGrpSpPr>
              <p:grpSpPr>
                <a:xfrm>
                  <a:off x="4851385" y="910972"/>
                  <a:ext cx="141343" cy="330765"/>
                  <a:chOff x="4728410" y="1646186"/>
                  <a:chExt cx="348916" cy="808255"/>
                </a:xfrm>
              </p:grpSpPr>
              <p:sp>
                <p:nvSpPr>
                  <p:cNvPr id="28" name="Trapezoid 27"/>
                  <p:cNvSpPr/>
                  <p:nvPr/>
                </p:nvSpPr>
                <p:spPr>
                  <a:xfrm rot="10800000">
                    <a:off x="4728410" y="2129588"/>
                    <a:ext cx="348916" cy="324853"/>
                  </a:xfrm>
                  <a:prstGeom prst="trapezoid">
                    <a:avLst>
                      <a:gd name="adj" fmla="val 26580"/>
                    </a:avLst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" name="Freeform 28"/>
                  <p:cNvSpPr/>
                  <p:nvPr/>
                </p:nvSpPr>
                <p:spPr>
                  <a:xfrm>
                    <a:off x="4860760" y="1708483"/>
                    <a:ext cx="84220" cy="559468"/>
                  </a:xfrm>
                  <a:custGeom>
                    <a:avLst/>
                    <a:gdLst>
                      <a:gd name="connsiteX0" fmla="*/ 36699 w 120921"/>
                      <a:gd name="connsiteY0" fmla="*/ 1022685 h 1022685"/>
                      <a:gd name="connsiteX1" fmla="*/ 72794 w 120921"/>
                      <a:gd name="connsiteY1" fmla="*/ 685800 h 1022685"/>
                      <a:gd name="connsiteX2" fmla="*/ 605 w 120921"/>
                      <a:gd name="connsiteY2" fmla="*/ 288758 h 1022685"/>
                      <a:gd name="connsiteX3" fmla="*/ 120921 w 120921"/>
                      <a:gd name="connsiteY3" fmla="*/ 0 h 102268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20921" h="1022685">
                        <a:moveTo>
                          <a:pt x="36699" y="1022685"/>
                        </a:moveTo>
                        <a:cubicBezTo>
                          <a:pt x="57754" y="915403"/>
                          <a:pt x="78810" y="808121"/>
                          <a:pt x="72794" y="685800"/>
                        </a:cubicBezTo>
                        <a:cubicBezTo>
                          <a:pt x="66778" y="563479"/>
                          <a:pt x="-7416" y="403058"/>
                          <a:pt x="605" y="288758"/>
                        </a:cubicBezTo>
                        <a:cubicBezTo>
                          <a:pt x="8626" y="174458"/>
                          <a:pt x="102874" y="54142"/>
                          <a:pt x="120921" y="0"/>
                        </a:cubicBezTo>
                      </a:path>
                    </a:pathLst>
                  </a:custGeom>
                  <a:noFill/>
                  <a:ln>
                    <a:solidFill>
                      <a:srgbClr val="00B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0" name="Oval 29"/>
                  <p:cNvSpPr/>
                  <p:nvPr/>
                </p:nvSpPr>
                <p:spPr>
                  <a:xfrm rot="2661292" flipH="1">
                    <a:off x="4862109" y="1665564"/>
                    <a:ext cx="89204" cy="45719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" name="Oval 30"/>
                  <p:cNvSpPr/>
                  <p:nvPr/>
                </p:nvSpPr>
                <p:spPr>
                  <a:xfrm rot="2060320" flipV="1">
                    <a:off x="4921067" y="1921042"/>
                    <a:ext cx="59461" cy="129716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" name="Oval 31"/>
                  <p:cNvSpPr/>
                  <p:nvPr/>
                </p:nvSpPr>
                <p:spPr>
                  <a:xfrm rot="1383139">
                    <a:off x="4736678" y="1826313"/>
                    <a:ext cx="125950" cy="77157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3" name="Oval 32"/>
                  <p:cNvSpPr/>
                  <p:nvPr/>
                </p:nvSpPr>
                <p:spPr>
                  <a:xfrm rot="19895792" flipH="1">
                    <a:off x="4934175" y="1646186"/>
                    <a:ext cx="116962" cy="76970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21" name="Group 20"/>
                <p:cNvGrpSpPr/>
                <p:nvPr/>
              </p:nvGrpSpPr>
              <p:grpSpPr>
                <a:xfrm>
                  <a:off x="5045625" y="914661"/>
                  <a:ext cx="141343" cy="330765"/>
                  <a:chOff x="4728410" y="1646186"/>
                  <a:chExt cx="348916" cy="808255"/>
                </a:xfrm>
              </p:grpSpPr>
              <p:sp>
                <p:nvSpPr>
                  <p:cNvPr id="22" name="Trapezoid 21"/>
                  <p:cNvSpPr/>
                  <p:nvPr/>
                </p:nvSpPr>
                <p:spPr>
                  <a:xfrm rot="10800000">
                    <a:off x="4728410" y="2129588"/>
                    <a:ext cx="348916" cy="324853"/>
                  </a:xfrm>
                  <a:prstGeom prst="trapezoid">
                    <a:avLst>
                      <a:gd name="adj" fmla="val 26580"/>
                    </a:avLst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" name="Freeform 22"/>
                  <p:cNvSpPr/>
                  <p:nvPr/>
                </p:nvSpPr>
                <p:spPr>
                  <a:xfrm>
                    <a:off x="4860760" y="1708483"/>
                    <a:ext cx="84220" cy="559468"/>
                  </a:xfrm>
                  <a:custGeom>
                    <a:avLst/>
                    <a:gdLst>
                      <a:gd name="connsiteX0" fmla="*/ 36699 w 120921"/>
                      <a:gd name="connsiteY0" fmla="*/ 1022685 h 1022685"/>
                      <a:gd name="connsiteX1" fmla="*/ 72794 w 120921"/>
                      <a:gd name="connsiteY1" fmla="*/ 685800 h 1022685"/>
                      <a:gd name="connsiteX2" fmla="*/ 605 w 120921"/>
                      <a:gd name="connsiteY2" fmla="*/ 288758 h 1022685"/>
                      <a:gd name="connsiteX3" fmla="*/ 120921 w 120921"/>
                      <a:gd name="connsiteY3" fmla="*/ 0 h 102268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20921" h="1022685">
                        <a:moveTo>
                          <a:pt x="36699" y="1022685"/>
                        </a:moveTo>
                        <a:cubicBezTo>
                          <a:pt x="57754" y="915403"/>
                          <a:pt x="78810" y="808121"/>
                          <a:pt x="72794" y="685800"/>
                        </a:cubicBezTo>
                        <a:cubicBezTo>
                          <a:pt x="66778" y="563479"/>
                          <a:pt x="-7416" y="403058"/>
                          <a:pt x="605" y="288758"/>
                        </a:cubicBezTo>
                        <a:cubicBezTo>
                          <a:pt x="8626" y="174458"/>
                          <a:pt x="102874" y="54142"/>
                          <a:pt x="120921" y="0"/>
                        </a:cubicBezTo>
                      </a:path>
                    </a:pathLst>
                  </a:custGeom>
                  <a:noFill/>
                  <a:ln>
                    <a:solidFill>
                      <a:srgbClr val="00B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" name="Oval 23"/>
                  <p:cNvSpPr/>
                  <p:nvPr/>
                </p:nvSpPr>
                <p:spPr>
                  <a:xfrm rot="2661292" flipH="1">
                    <a:off x="4862109" y="1665564"/>
                    <a:ext cx="89204" cy="45719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" name="Oval 24"/>
                  <p:cNvSpPr/>
                  <p:nvPr/>
                </p:nvSpPr>
                <p:spPr>
                  <a:xfrm rot="2060320" flipV="1">
                    <a:off x="4921067" y="1921042"/>
                    <a:ext cx="59461" cy="129716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" name="Oval 25"/>
                  <p:cNvSpPr/>
                  <p:nvPr/>
                </p:nvSpPr>
                <p:spPr>
                  <a:xfrm rot="1383139">
                    <a:off x="4736678" y="1826313"/>
                    <a:ext cx="125950" cy="77157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" name="Oval 26"/>
                  <p:cNvSpPr/>
                  <p:nvPr/>
                </p:nvSpPr>
                <p:spPr>
                  <a:xfrm rot="19895792" flipH="1">
                    <a:off x="4934175" y="1646186"/>
                    <a:ext cx="116962" cy="76970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sp>
          <p:nvSpPr>
            <p:cNvPr id="267" name="TextBox 266"/>
            <p:cNvSpPr txBox="1"/>
            <p:nvPr/>
          </p:nvSpPr>
          <p:spPr>
            <a:xfrm>
              <a:off x="3350421" y="2328856"/>
              <a:ext cx="681111" cy="369332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TextBox 267"/>
            <p:cNvSpPr txBox="1"/>
            <p:nvPr/>
          </p:nvSpPr>
          <p:spPr>
            <a:xfrm>
              <a:off x="4163400" y="2323865"/>
              <a:ext cx="655742" cy="369332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HL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69" name="Group 268"/>
            <p:cNvGrpSpPr/>
            <p:nvPr/>
          </p:nvGrpSpPr>
          <p:grpSpPr>
            <a:xfrm>
              <a:off x="3616140" y="2145339"/>
              <a:ext cx="916272" cy="153276"/>
              <a:chOff x="1519251" y="2750034"/>
              <a:chExt cx="7140779" cy="491086"/>
            </a:xfrm>
          </p:grpSpPr>
          <p:cxnSp>
            <p:nvCxnSpPr>
              <p:cNvPr id="270" name="Straight Connector 269"/>
              <p:cNvCxnSpPr/>
              <p:nvPr/>
            </p:nvCxnSpPr>
            <p:spPr>
              <a:xfrm>
                <a:off x="1519251" y="2750034"/>
                <a:ext cx="7126715" cy="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1" name="Straight Connector 270"/>
              <p:cNvCxnSpPr/>
              <p:nvPr/>
            </p:nvCxnSpPr>
            <p:spPr>
              <a:xfrm>
                <a:off x="1535141" y="2750526"/>
                <a:ext cx="0" cy="490594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2" name="Straight Connector 271"/>
              <p:cNvCxnSpPr/>
              <p:nvPr/>
            </p:nvCxnSpPr>
            <p:spPr>
              <a:xfrm>
                <a:off x="8660030" y="2750034"/>
                <a:ext cx="0" cy="490594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3" name="Group 272"/>
            <p:cNvGrpSpPr/>
            <p:nvPr/>
          </p:nvGrpSpPr>
          <p:grpSpPr>
            <a:xfrm>
              <a:off x="3658856" y="1474111"/>
              <a:ext cx="760684" cy="644824"/>
              <a:chOff x="2078744" y="1186739"/>
              <a:chExt cx="760684" cy="644824"/>
            </a:xfrm>
          </p:grpSpPr>
          <p:sp>
            <p:nvSpPr>
              <p:cNvPr id="274" name="TextBox 273"/>
              <p:cNvSpPr txBox="1"/>
              <p:nvPr/>
            </p:nvSpPr>
            <p:spPr>
              <a:xfrm>
                <a:off x="2078744" y="1186739"/>
                <a:ext cx="76068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SV</a:t>
                </a:r>
                <a:endParaRPr lang="zh-CN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75" name="Group 274"/>
              <p:cNvGrpSpPr/>
              <p:nvPr/>
            </p:nvGrpSpPr>
            <p:grpSpPr>
              <a:xfrm>
                <a:off x="2193600" y="1497109"/>
                <a:ext cx="531040" cy="334454"/>
                <a:chOff x="4655928" y="910972"/>
                <a:chExt cx="531040" cy="334454"/>
              </a:xfrm>
            </p:grpSpPr>
            <p:grpSp>
              <p:nvGrpSpPr>
                <p:cNvPr id="276" name="Group 275"/>
                <p:cNvGrpSpPr/>
                <p:nvPr/>
              </p:nvGrpSpPr>
              <p:grpSpPr>
                <a:xfrm>
                  <a:off x="4655928" y="912312"/>
                  <a:ext cx="141343" cy="330765"/>
                  <a:chOff x="4728410" y="1646186"/>
                  <a:chExt cx="348916" cy="808255"/>
                </a:xfrm>
              </p:grpSpPr>
              <p:sp>
                <p:nvSpPr>
                  <p:cNvPr id="291" name="Trapezoid 290"/>
                  <p:cNvSpPr/>
                  <p:nvPr/>
                </p:nvSpPr>
                <p:spPr>
                  <a:xfrm rot="10800000">
                    <a:off x="4728410" y="2129588"/>
                    <a:ext cx="348916" cy="324853"/>
                  </a:xfrm>
                  <a:prstGeom prst="trapezoid">
                    <a:avLst>
                      <a:gd name="adj" fmla="val 26580"/>
                    </a:avLst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2" name="Freeform 291"/>
                  <p:cNvSpPr/>
                  <p:nvPr/>
                </p:nvSpPr>
                <p:spPr>
                  <a:xfrm>
                    <a:off x="4860760" y="1708483"/>
                    <a:ext cx="84220" cy="559468"/>
                  </a:xfrm>
                  <a:custGeom>
                    <a:avLst/>
                    <a:gdLst>
                      <a:gd name="connsiteX0" fmla="*/ 36699 w 120921"/>
                      <a:gd name="connsiteY0" fmla="*/ 1022685 h 1022685"/>
                      <a:gd name="connsiteX1" fmla="*/ 72794 w 120921"/>
                      <a:gd name="connsiteY1" fmla="*/ 685800 h 1022685"/>
                      <a:gd name="connsiteX2" fmla="*/ 605 w 120921"/>
                      <a:gd name="connsiteY2" fmla="*/ 288758 h 1022685"/>
                      <a:gd name="connsiteX3" fmla="*/ 120921 w 120921"/>
                      <a:gd name="connsiteY3" fmla="*/ 0 h 102268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20921" h="1022685">
                        <a:moveTo>
                          <a:pt x="36699" y="1022685"/>
                        </a:moveTo>
                        <a:cubicBezTo>
                          <a:pt x="57754" y="915403"/>
                          <a:pt x="78810" y="808121"/>
                          <a:pt x="72794" y="685800"/>
                        </a:cubicBezTo>
                        <a:cubicBezTo>
                          <a:pt x="66778" y="563479"/>
                          <a:pt x="-7416" y="403058"/>
                          <a:pt x="605" y="288758"/>
                        </a:cubicBezTo>
                        <a:cubicBezTo>
                          <a:pt x="8626" y="174458"/>
                          <a:pt x="102874" y="54142"/>
                          <a:pt x="120921" y="0"/>
                        </a:cubicBezTo>
                      </a:path>
                    </a:pathLst>
                  </a:custGeom>
                  <a:noFill/>
                  <a:ln>
                    <a:solidFill>
                      <a:srgbClr val="00B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3" name="Oval 292"/>
                  <p:cNvSpPr/>
                  <p:nvPr/>
                </p:nvSpPr>
                <p:spPr>
                  <a:xfrm rot="2661292" flipH="1">
                    <a:off x="4862109" y="1665564"/>
                    <a:ext cx="89204" cy="45719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4" name="Oval 293"/>
                  <p:cNvSpPr/>
                  <p:nvPr/>
                </p:nvSpPr>
                <p:spPr>
                  <a:xfrm rot="2060320" flipV="1">
                    <a:off x="4921067" y="1921042"/>
                    <a:ext cx="59461" cy="129716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5" name="Oval 294"/>
                  <p:cNvSpPr/>
                  <p:nvPr/>
                </p:nvSpPr>
                <p:spPr>
                  <a:xfrm rot="1383139">
                    <a:off x="4736678" y="1826313"/>
                    <a:ext cx="125950" cy="77157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6" name="Oval 295"/>
                  <p:cNvSpPr/>
                  <p:nvPr/>
                </p:nvSpPr>
                <p:spPr>
                  <a:xfrm rot="19895792" flipH="1">
                    <a:off x="4934175" y="1646186"/>
                    <a:ext cx="116962" cy="76970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277" name="Group 276"/>
                <p:cNvGrpSpPr/>
                <p:nvPr/>
              </p:nvGrpSpPr>
              <p:grpSpPr>
                <a:xfrm>
                  <a:off x="4851385" y="910972"/>
                  <a:ext cx="141343" cy="330765"/>
                  <a:chOff x="4728410" y="1646186"/>
                  <a:chExt cx="348916" cy="808255"/>
                </a:xfrm>
              </p:grpSpPr>
              <p:sp>
                <p:nvSpPr>
                  <p:cNvPr id="285" name="Trapezoid 284"/>
                  <p:cNvSpPr/>
                  <p:nvPr/>
                </p:nvSpPr>
                <p:spPr>
                  <a:xfrm rot="10800000">
                    <a:off x="4728410" y="2129588"/>
                    <a:ext cx="348916" cy="324853"/>
                  </a:xfrm>
                  <a:prstGeom prst="trapezoid">
                    <a:avLst>
                      <a:gd name="adj" fmla="val 26580"/>
                    </a:avLst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6" name="Freeform 285"/>
                  <p:cNvSpPr/>
                  <p:nvPr/>
                </p:nvSpPr>
                <p:spPr>
                  <a:xfrm>
                    <a:off x="4860760" y="1708483"/>
                    <a:ext cx="84220" cy="559468"/>
                  </a:xfrm>
                  <a:custGeom>
                    <a:avLst/>
                    <a:gdLst>
                      <a:gd name="connsiteX0" fmla="*/ 36699 w 120921"/>
                      <a:gd name="connsiteY0" fmla="*/ 1022685 h 1022685"/>
                      <a:gd name="connsiteX1" fmla="*/ 72794 w 120921"/>
                      <a:gd name="connsiteY1" fmla="*/ 685800 h 1022685"/>
                      <a:gd name="connsiteX2" fmla="*/ 605 w 120921"/>
                      <a:gd name="connsiteY2" fmla="*/ 288758 h 1022685"/>
                      <a:gd name="connsiteX3" fmla="*/ 120921 w 120921"/>
                      <a:gd name="connsiteY3" fmla="*/ 0 h 102268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20921" h="1022685">
                        <a:moveTo>
                          <a:pt x="36699" y="1022685"/>
                        </a:moveTo>
                        <a:cubicBezTo>
                          <a:pt x="57754" y="915403"/>
                          <a:pt x="78810" y="808121"/>
                          <a:pt x="72794" y="685800"/>
                        </a:cubicBezTo>
                        <a:cubicBezTo>
                          <a:pt x="66778" y="563479"/>
                          <a:pt x="-7416" y="403058"/>
                          <a:pt x="605" y="288758"/>
                        </a:cubicBezTo>
                        <a:cubicBezTo>
                          <a:pt x="8626" y="174458"/>
                          <a:pt x="102874" y="54142"/>
                          <a:pt x="120921" y="0"/>
                        </a:cubicBezTo>
                      </a:path>
                    </a:pathLst>
                  </a:custGeom>
                  <a:noFill/>
                  <a:ln>
                    <a:solidFill>
                      <a:srgbClr val="00B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7" name="Oval 286"/>
                  <p:cNvSpPr/>
                  <p:nvPr/>
                </p:nvSpPr>
                <p:spPr>
                  <a:xfrm rot="2661292" flipH="1">
                    <a:off x="4862109" y="1665564"/>
                    <a:ext cx="89204" cy="45719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8" name="Oval 287"/>
                  <p:cNvSpPr/>
                  <p:nvPr/>
                </p:nvSpPr>
                <p:spPr>
                  <a:xfrm rot="2060320" flipV="1">
                    <a:off x="4921067" y="1921042"/>
                    <a:ext cx="59461" cy="129716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9" name="Oval 288"/>
                  <p:cNvSpPr/>
                  <p:nvPr/>
                </p:nvSpPr>
                <p:spPr>
                  <a:xfrm rot="1383139">
                    <a:off x="4736678" y="1826313"/>
                    <a:ext cx="125950" cy="77157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0" name="Oval 289"/>
                  <p:cNvSpPr/>
                  <p:nvPr/>
                </p:nvSpPr>
                <p:spPr>
                  <a:xfrm rot="19895792" flipH="1">
                    <a:off x="4934175" y="1646186"/>
                    <a:ext cx="116962" cy="76970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278" name="Group 277"/>
                <p:cNvGrpSpPr/>
                <p:nvPr/>
              </p:nvGrpSpPr>
              <p:grpSpPr>
                <a:xfrm>
                  <a:off x="5045625" y="914661"/>
                  <a:ext cx="141343" cy="330765"/>
                  <a:chOff x="4728410" y="1646186"/>
                  <a:chExt cx="348916" cy="808255"/>
                </a:xfrm>
              </p:grpSpPr>
              <p:sp>
                <p:nvSpPr>
                  <p:cNvPr id="279" name="Trapezoid 278"/>
                  <p:cNvSpPr/>
                  <p:nvPr/>
                </p:nvSpPr>
                <p:spPr>
                  <a:xfrm rot="10800000">
                    <a:off x="4728410" y="2129588"/>
                    <a:ext cx="348916" cy="324853"/>
                  </a:xfrm>
                  <a:prstGeom prst="trapezoid">
                    <a:avLst>
                      <a:gd name="adj" fmla="val 26580"/>
                    </a:avLst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0" name="Freeform 279"/>
                  <p:cNvSpPr/>
                  <p:nvPr/>
                </p:nvSpPr>
                <p:spPr>
                  <a:xfrm>
                    <a:off x="4860760" y="1708483"/>
                    <a:ext cx="84220" cy="559468"/>
                  </a:xfrm>
                  <a:custGeom>
                    <a:avLst/>
                    <a:gdLst>
                      <a:gd name="connsiteX0" fmla="*/ 36699 w 120921"/>
                      <a:gd name="connsiteY0" fmla="*/ 1022685 h 1022685"/>
                      <a:gd name="connsiteX1" fmla="*/ 72794 w 120921"/>
                      <a:gd name="connsiteY1" fmla="*/ 685800 h 1022685"/>
                      <a:gd name="connsiteX2" fmla="*/ 605 w 120921"/>
                      <a:gd name="connsiteY2" fmla="*/ 288758 h 1022685"/>
                      <a:gd name="connsiteX3" fmla="*/ 120921 w 120921"/>
                      <a:gd name="connsiteY3" fmla="*/ 0 h 102268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20921" h="1022685">
                        <a:moveTo>
                          <a:pt x="36699" y="1022685"/>
                        </a:moveTo>
                        <a:cubicBezTo>
                          <a:pt x="57754" y="915403"/>
                          <a:pt x="78810" y="808121"/>
                          <a:pt x="72794" y="685800"/>
                        </a:cubicBezTo>
                        <a:cubicBezTo>
                          <a:pt x="66778" y="563479"/>
                          <a:pt x="-7416" y="403058"/>
                          <a:pt x="605" y="288758"/>
                        </a:cubicBezTo>
                        <a:cubicBezTo>
                          <a:pt x="8626" y="174458"/>
                          <a:pt x="102874" y="54142"/>
                          <a:pt x="120921" y="0"/>
                        </a:cubicBezTo>
                      </a:path>
                    </a:pathLst>
                  </a:custGeom>
                  <a:noFill/>
                  <a:ln>
                    <a:solidFill>
                      <a:srgbClr val="00B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1" name="Oval 280"/>
                  <p:cNvSpPr/>
                  <p:nvPr/>
                </p:nvSpPr>
                <p:spPr>
                  <a:xfrm rot="2661292" flipH="1">
                    <a:off x="4862109" y="1665564"/>
                    <a:ext cx="89204" cy="45719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2" name="Oval 281"/>
                  <p:cNvSpPr/>
                  <p:nvPr/>
                </p:nvSpPr>
                <p:spPr>
                  <a:xfrm rot="2060320" flipV="1">
                    <a:off x="4921067" y="1921042"/>
                    <a:ext cx="59461" cy="129716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3" name="Oval 282"/>
                  <p:cNvSpPr/>
                  <p:nvPr/>
                </p:nvSpPr>
                <p:spPr>
                  <a:xfrm rot="1383139">
                    <a:off x="4736678" y="1826313"/>
                    <a:ext cx="125950" cy="77157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4" name="Oval 283"/>
                  <p:cNvSpPr/>
                  <p:nvPr/>
                </p:nvSpPr>
                <p:spPr>
                  <a:xfrm rot="19895792" flipH="1">
                    <a:off x="4934175" y="1646186"/>
                    <a:ext cx="116962" cy="76970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</p:grpSp>
      <p:grpSp>
        <p:nvGrpSpPr>
          <p:cNvPr id="297" name="Group 296"/>
          <p:cNvGrpSpPr/>
          <p:nvPr/>
        </p:nvGrpSpPr>
        <p:grpSpPr>
          <a:xfrm>
            <a:off x="4518306" y="1088648"/>
            <a:ext cx="3268106" cy="1800493"/>
            <a:chOff x="1609047" y="1000125"/>
            <a:chExt cx="3268106" cy="1800493"/>
          </a:xfrm>
        </p:grpSpPr>
        <p:sp>
          <p:nvSpPr>
            <p:cNvPr id="298" name="TextBox 297"/>
            <p:cNvSpPr txBox="1"/>
            <p:nvPr/>
          </p:nvSpPr>
          <p:spPr>
            <a:xfrm>
              <a:off x="1609047" y="1000125"/>
              <a:ext cx="3268106" cy="1800493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100" b="1" dirty="0" smtClean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Bio-Rep2</a:t>
              </a:r>
            </a:p>
            <a:p>
              <a:endPara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9" name="TextBox 298"/>
            <p:cNvSpPr txBox="1"/>
            <p:nvPr/>
          </p:nvSpPr>
          <p:spPr>
            <a:xfrm>
              <a:off x="1675376" y="2339117"/>
              <a:ext cx="681111" cy="369332"/>
            </a:xfrm>
            <a:prstGeom prst="rect">
              <a:avLst/>
            </a:prstGeom>
            <a:solidFill>
              <a:srgbClr val="00B050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0" name="TextBox 299"/>
            <p:cNvSpPr txBox="1"/>
            <p:nvPr/>
          </p:nvSpPr>
          <p:spPr>
            <a:xfrm>
              <a:off x="2488355" y="2334126"/>
              <a:ext cx="655742" cy="369332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HL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01" name="Group 300"/>
            <p:cNvGrpSpPr/>
            <p:nvPr/>
          </p:nvGrpSpPr>
          <p:grpSpPr>
            <a:xfrm>
              <a:off x="1941095" y="2155600"/>
              <a:ext cx="916272" cy="153276"/>
              <a:chOff x="1519251" y="2750034"/>
              <a:chExt cx="7140779" cy="491086"/>
            </a:xfrm>
          </p:grpSpPr>
          <p:cxnSp>
            <p:nvCxnSpPr>
              <p:cNvPr id="356" name="Straight Connector 355"/>
              <p:cNvCxnSpPr/>
              <p:nvPr/>
            </p:nvCxnSpPr>
            <p:spPr>
              <a:xfrm>
                <a:off x="1519251" y="2750034"/>
                <a:ext cx="7126715" cy="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57" name="Straight Connector 356"/>
              <p:cNvCxnSpPr/>
              <p:nvPr/>
            </p:nvCxnSpPr>
            <p:spPr>
              <a:xfrm>
                <a:off x="1535141" y="2750526"/>
                <a:ext cx="0" cy="490594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58" name="Straight Connector 357"/>
              <p:cNvCxnSpPr/>
              <p:nvPr/>
            </p:nvCxnSpPr>
            <p:spPr>
              <a:xfrm>
                <a:off x="8660030" y="2750034"/>
                <a:ext cx="0" cy="490594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2" name="Group 301"/>
            <p:cNvGrpSpPr/>
            <p:nvPr/>
          </p:nvGrpSpPr>
          <p:grpSpPr>
            <a:xfrm>
              <a:off x="1945710" y="1484372"/>
              <a:ext cx="894523" cy="644824"/>
              <a:chOff x="2040643" y="1186739"/>
              <a:chExt cx="894523" cy="644824"/>
            </a:xfrm>
          </p:grpSpPr>
          <p:sp>
            <p:nvSpPr>
              <p:cNvPr id="333" name="TextBox 332"/>
              <p:cNvSpPr txBox="1"/>
              <p:nvPr/>
            </p:nvSpPr>
            <p:spPr>
              <a:xfrm>
                <a:off x="2040643" y="1186739"/>
                <a:ext cx="89452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lang="zh-CN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34" name="Group 333"/>
              <p:cNvGrpSpPr/>
              <p:nvPr/>
            </p:nvGrpSpPr>
            <p:grpSpPr>
              <a:xfrm>
                <a:off x="2193600" y="1497109"/>
                <a:ext cx="531040" cy="334454"/>
                <a:chOff x="4655928" y="910972"/>
                <a:chExt cx="531040" cy="334454"/>
              </a:xfrm>
            </p:grpSpPr>
            <p:grpSp>
              <p:nvGrpSpPr>
                <p:cNvPr id="335" name="Group 334"/>
                <p:cNvGrpSpPr/>
                <p:nvPr/>
              </p:nvGrpSpPr>
              <p:grpSpPr>
                <a:xfrm>
                  <a:off x="4655928" y="912312"/>
                  <a:ext cx="141343" cy="330765"/>
                  <a:chOff x="4728410" y="1646186"/>
                  <a:chExt cx="348916" cy="808255"/>
                </a:xfrm>
              </p:grpSpPr>
              <p:sp>
                <p:nvSpPr>
                  <p:cNvPr id="350" name="Trapezoid 349"/>
                  <p:cNvSpPr/>
                  <p:nvPr/>
                </p:nvSpPr>
                <p:spPr>
                  <a:xfrm rot="10800000">
                    <a:off x="4728410" y="2129588"/>
                    <a:ext cx="348916" cy="324853"/>
                  </a:xfrm>
                  <a:prstGeom prst="trapezoid">
                    <a:avLst>
                      <a:gd name="adj" fmla="val 26580"/>
                    </a:avLst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1" name="Freeform 350"/>
                  <p:cNvSpPr/>
                  <p:nvPr/>
                </p:nvSpPr>
                <p:spPr>
                  <a:xfrm>
                    <a:off x="4860760" y="1708483"/>
                    <a:ext cx="84220" cy="559468"/>
                  </a:xfrm>
                  <a:custGeom>
                    <a:avLst/>
                    <a:gdLst>
                      <a:gd name="connsiteX0" fmla="*/ 36699 w 120921"/>
                      <a:gd name="connsiteY0" fmla="*/ 1022685 h 1022685"/>
                      <a:gd name="connsiteX1" fmla="*/ 72794 w 120921"/>
                      <a:gd name="connsiteY1" fmla="*/ 685800 h 1022685"/>
                      <a:gd name="connsiteX2" fmla="*/ 605 w 120921"/>
                      <a:gd name="connsiteY2" fmla="*/ 288758 h 1022685"/>
                      <a:gd name="connsiteX3" fmla="*/ 120921 w 120921"/>
                      <a:gd name="connsiteY3" fmla="*/ 0 h 102268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20921" h="1022685">
                        <a:moveTo>
                          <a:pt x="36699" y="1022685"/>
                        </a:moveTo>
                        <a:cubicBezTo>
                          <a:pt x="57754" y="915403"/>
                          <a:pt x="78810" y="808121"/>
                          <a:pt x="72794" y="685800"/>
                        </a:cubicBezTo>
                        <a:cubicBezTo>
                          <a:pt x="66778" y="563479"/>
                          <a:pt x="-7416" y="403058"/>
                          <a:pt x="605" y="288758"/>
                        </a:cubicBezTo>
                        <a:cubicBezTo>
                          <a:pt x="8626" y="174458"/>
                          <a:pt x="102874" y="54142"/>
                          <a:pt x="120921" y="0"/>
                        </a:cubicBezTo>
                      </a:path>
                    </a:pathLst>
                  </a:custGeom>
                  <a:noFill/>
                  <a:ln>
                    <a:solidFill>
                      <a:srgbClr val="00B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2" name="Oval 351"/>
                  <p:cNvSpPr/>
                  <p:nvPr/>
                </p:nvSpPr>
                <p:spPr>
                  <a:xfrm rot="2661292" flipH="1">
                    <a:off x="4862109" y="1665564"/>
                    <a:ext cx="89204" cy="45719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3" name="Oval 352"/>
                  <p:cNvSpPr/>
                  <p:nvPr/>
                </p:nvSpPr>
                <p:spPr>
                  <a:xfrm rot="2060320" flipV="1">
                    <a:off x="4921067" y="1921042"/>
                    <a:ext cx="59461" cy="129716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4" name="Oval 353"/>
                  <p:cNvSpPr/>
                  <p:nvPr/>
                </p:nvSpPr>
                <p:spPr>
                  <a:xfrm rot="1383139">
                    <a:off x="4736678" y="1826313"/>
                    <a:ext cx="125950" cy="77157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5" name="Oval 354"/>
                  <p:cNvSpPr/>
                  <p:nvPr/>
                </p:nvSpPr>
                <p:spPr>
                  <a:xfrm rot="19895792" flipH="1">
                    <a:off x="4934175" y="1646186"/>
                    <a:ext cx="116962" cy="76970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36" name="Group 335"/>
                <p:cNvGrpSpPr/>
                <p:nvPr/>
              </p:nvGrpSpPr>
              <p:grpSpPr>
                <a:xfrm>
                  <a:off x="4851385" y="910972"/>
                  <a:ext cx="141343" cy="330765"/>
                  <a:chOff x="4728410" y="1646186"/>
                  <a:chExt cx="348916" cy="808255"/>
                </a:xfrm>
              </p:grpSpPr>
              <p:sp>
                <p:nvSpPr>
                  <p:cNvPr id="344" name="Trapezoid 343"/>
                  <p:cNvSpPr/>
                  <p:nvPr/>
                </p:nvSpPr>
                <p:spPr>
                  <a:xfrm rot="10800000">
                    <a:off x="4728410" y="2129588"/>
                    <a:ext cx="348916" cy="324853"/>
                  </a:xfrm>
                  <a:prstGeom prst="trapezoid">
                    <a:avLst>
                      <a:gd name="adj" fmla="val 26580"/>
                    </a:avLst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5" name="Freeform 344"/>
                  <p:cNvSpPr/>
                  <p:nvPr/>
                </p:nvSpPr>
                <p:spPr>
                  <a:xfrm>
                    <a:off x="4860760" y="1708483"/>
                    <a:ext cx="84220" cy="559468"/>
                  </a:xfrm>
                  <a:custGeom>
                    <a:avLst/>
                    <a:gdLst>
                      <a:gd name="connsiteX0" fmla="*/ 36699 w 120921"/>
                      <a:gd name="connsiteY0" fmla="*/ 1022685 h 1022685"/>
                      <a:gd name="connsiteX1" fmla="*/ 72794 w 120921"/>
                      <a:gd name="connsiteY1" fmla="*/ 685800 h 1022685"/>
                      <a:gd name="connsiteX2" fmla="*/ 605 w 120921"/>
                      <a:gd name="connsiteY2" fmla="*/ 288758 h 1022685"/>
                      <a:gd name="connsiteX3" fmla="*/ 120921 w 120921"/>
                      <a:gd name="connsiteY3" fmla="*/ 0 h 102268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20921" h="1022685">
                        <a:moveTo>
                          <a:pt x="36699" y="1022685"/>
                        </a:moveTo>
                        <a:cubicBezTo>
                          <a:pt x="57754" y="915403"/>
                          <a:pt x="78810" y="808121"/>
                          <a:pt x="72794" y="685800"/>
                        </a:cubicBezTo>
                        <a:cubicBezTo>
                          <a:pt x="66778" y="563479"/>
                          <a:pt x="-7416" y="403058"/>
                          <a:pt x="605" y="288758"/>
                        </a:cubicBezTo>
                        <a:cubicBezTo>
                          <a:pt x="8626" y="174458"/>
                          <a:pt x="102874" y="54142"/>
                          <a:pt x="120921" y="0"/>
                        </a:cubicBezTo>
                      </a:path>
                    </a:pathLst>
                  </a:custGeom>
                  <a:noFill/>
                  <a:ln>
                    <a:solidFill>
                      <a:srgbClr val="00B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6" name="Oval 345"/>
                  <p:cNvSpPr/>
                  <p:nvPr/>
                </p:nvSpPr>
                <p:spPr>
                  <a:xfrm rot="2661292" flipH="1">
                    <a:off x="4862109" y="1665564"/>
                    <a:ext cx="89204" cy="45719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7" name="Oval 346"/>
                  <p:cNvSpPr/>
                  <p:nvPr/>
                </p:nvSpPr>
                <p:spPr>
                  <a:xfrm rot="2060320" flipV="1">
                    <a:off x="4921067" y="1921042"/>
                    <a:ext cx="59461" cy="129716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8" name="Oval 347"/>
                  <p:cNvSpPr/>
                  <p:nvPr/>
                </p:nvSpPr>
                <p:spPr>
                  <a:xfrm rot="1383139">
                    <a:off x="4736678" y="1826313"/>
                    <a:ext cx="125950" cy="77157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9" name="Oval 348"/>
                  <p:cNvSpPr/>
                  <p:nvPr/>
                </p:nvSpPr>
                <p:spPr>
                  <a:xfrm rot="19895792" flipH="1">
                    <a:off x="4934175" y="1646186"/>
                    <a:ext cx="116962" cy="76970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37" name="Group 336"/>
                <p:cNvGrpSpPr/>
                <p:nvPr/>
              </p:nvGrpSpPr>
              <p:grpSpPr>
                <a:xfrm>
                  <a:off x="5045625" y="914661"/>
                  <a:ext cx="141343" cy="330765"/>
                  <a:chOff x="4728410" y="1646186"/>
                  <a:chExt cx="348916" cy="808255"/>
                </a:xfrm>
              </p:grpSpPr>
              <p:sp>
                <p:nvSpPr>
                  <p:cNvPr id="338" name="Trapezoid 337"/>
                  <p:cNvSpPr/>
                  <p:nvPr/>
                </p:nvSpPr>
                <p:spPr>
                  <a:xfrm rot="10800000">
                    <a:off x="4728410" y="2129588"/>
                    <a:ext cx="348916" cy="324853"/>
                  </a:xfrm>
                  <a:prstGeom prst="trapezoid">
                    <a:avLst>
                      <a:gd name="adj" fmla="val 26580"/>
                    </a:avLst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39" name="Freeform 338"/>
                  <p:cNvSpPr/>
                  <p:nvPr/>
                </p:nvSpPr>
                <p:spPr>
                  <a:xfrm>
                    <a:off x="4860760" y="1708483"/>
                    <a:ext cx="84220" cy="559468"/>
                  </a:xfrm>
                  <a:custGeom>
                    <a:avLst/>
                    <a:gdLst>
                      <a:gd name="connsiteX0" fmla="*/ 36699 w 120921"/>
                      <a:gd name="connsiteY0" fmla="*/ 1022685 h 1022685"/>
                      <a:gd name="connsiteX1" fmla="*/ 72794 w 120921"/>
                      <a:gd name="connsiteY1" fmla="*/ 685800 h 1022685"/>
                      <a:gd name="connsiteX2" fmla="*/ 605 w 120921"/>
                      <a:gd name="connsiteY2" fmla="*/ 288758 h 1022685"/>
                      <a:gd name="connsiteX3" fmla="*/ 120921 w 120921"/>
                      <a:gd name="connsiteY3" fmla="*/ 0 h 102268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20921" h="1022685">
                        <a:moveTo>
                          <a:pt x="36699" y="1022685"/>
                        </a:moveTo>
                        <a:cubicBezTo>
                          <a:pt x="57754" y="915403"/>
                          <a:pt x="78810" y="808121"/>
                          <a:pt x="72794" y="685800"/>
                        </a:cubicBezTo>
                        <a:cubicBezTo>
                          <a:pt x="66778" y="563479"/>
                          <a:pt x="-7416" y="403058"/>
                          <a:pt x="605" y="288758"/>
                        </a:cubicBezTo>
                        <a:cubicBezTo>
                          <a:pt x="8626" y="174458"/>
                          <a:pt x="102874" y="54142"/>
                          <a:pt x="120921" y="0"/>
                        </a:cubicBezTo>
                      </a:path>
                    </a:pathLst>
                  </a:custGeom>
                  <a:noFill/>
                  <a:ln>
                    <a:solidFill>
                      <a:srgbClr val="00B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0" name="Oval 339"/>
                  <p:cNvSpPr/>
                  <p:nvPr/>
                </p:nvSpPr>
                <p:spPr>
                  <a:xfrm rot="2661292" flipH="1">
                    <a:off x="4862109" y="1665564"/>
                    <a:ext cx="89204" cy="45719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1" name="Oval 340"/>
                  <p:cNvSpPr/>
                  <p:nvPr/>
                </p:nvSpPr>
                <p:spPr>
                  <a:xfrm rot="2060320" flipV="1">
                    <a:off x="4921067" y="1921042"/>
                    <a:ext cx="59461" cy="129716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2" name="Oval 341"/>
                  <p:cNvSpPr/>
                  <p:nvPr/>
                </p:nvSpPr>
                <p:spPr>
                  <a:xfrm rot="1383139">
                    <a:off x="4736678" y="1826313"/>
                    <a:ext cx="125950" cy="77157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3" name="Oval 342"/>
                  <p:cNvSpPr/>
                  <p:nvPr/>
                </p:nvSpPr>
                <p:spPr>
                  <a:xfrm rot="19895792" flipH="1">
                    <a:off x="4934175" y="1646186"/>
                    <a:ext cx="116962" cy="76970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sp>
          <p:nvSpPr>
            <p:cNvPr id="303" name="TextBox 302"/>
            <p:cNvSpPr txBox="1"/>
            <p:nvPr/>
          </p:nvSpPr>
          <p:spPr>
            <a:xfrm>
              <a:off x="3350421" y="2328856"/>
              <a:ext cx="681111" cy="369332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4" name="TextBox 303"/>
            <p:cNvSpPr txBox="1"/>
            <p:nvPr/>
          </p:nvSpPr>
          <p:spPr>
            <a:xfrm>
              <a:off x="4163400" y="2323865"/>
              <a:ext cx="655742" cy="369332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HL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05" name="Group 304"/>
            <p:cNvGrpSpPr/>
            <p:nvPr/>
          </p:nvGrpSpPr>
          <p:grpSpPr>
            <a:xfrm>
              <a:off x="3616140" y="2145339"/>
              <a:ext cx="916272" cy="153276"/>
              <a:chOff x="1519251" y="2750034"/>
              <a:chExt cx="7140779" cy="491086"/>
            </a:xfrm>
          </p:grpSpPr>
          <p:cxnSp>
            <p:nvCxnSpPr>
              <p:cNvPr id="330" name="Straight Connector 329"/>
              <p:cNvCxnSpPr/>
              <p:nvPr/>
            </p:nvCxnSpPr>
            <p:spPr>
              <a:xfrm>
                <a:off x="1519251" y="2750034"/>
                <a:ext cx="7126715" cy="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31" name="Straight Connector 330"/>
              <p:cNvCxnSpPr/>
              <p:nvPr/>
            </p:nvCxnSpPr>
            <p:spPr>
              <a:xfrm>
                <a:off x="1535141" y="2750526"/>
                <a:ext cx="0" cy="490594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32" name="Straight Connector 331"/>
              <p:cNvCxnSpPr/>
              <p:nvPr/>
            </p:nvCxnSpPr>
            <p:spPr>
              <a:xfrm>
                <a:off x="8660030" y="2750034"/>
                <a:ext cx="0" cy="490594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6" name="Group 305"/>
            <p:cNvGrpSpPr/>
            <p:nvPr/>
          </p:nvGrpSpPr>
          <p:grpSpPr>
            <a:xfrm>
              <a:off x="3658856" y="1474111"/>
              <a:ext cx="760684" cy="644824"/>
              <a:chOff x="2078744" y="1186739"/>
              <a:chExt cx="760684" cy="644824"/>
            </a:xfrm>
          </p:grpSpPr>
          <p:sp>
            <p:nvSpPr>
              <p:cNvPr id="307" name="TextBox 306"/>
              <p:cNvSpPr txBox="1"/>
              <p:nvPr/>
            </p:nvSpPr>
            <p:spPr>
              <a:xfrm>
                <a:off x="2078744" y="1186739"/>
                <a:ext cx="76068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SV</a:t>
                </a:r>
                <a:endParaRPr lang="zh-CN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08" name="Group 307"/>
              <p:cNvGrpSpPr/>
              <p:nvPr/>
            </p:nvGrpSpPr>
            <p:grpSpPr>
              <a:xfrm>
                <a:off x="2193600" y="1497109"/>
                <a:ext cx="531040" cy="334454"/>
                <a:chOff x="4655928" y="910972"/>
                <a:chExt cx="531040" cy="334454"/>
              </a:xfrm>
            </p:grpSpPr>
            <p:grpSp>
              <p:nvGrpSpPr>
                <p:cNvPr id="309" name="Group 308"/>
                <p:cNvGrpSpPr/>
                <p:nvPr/>
              </p:nvGrpSpPr>
              <p:grpSpPr>
                <a:xfrm>
                  <a:off x="4655928" y="912312"/>
                  <a:ext cx="141343" cy="330765"/>
                  <a:chOff x="4728410" y="1646186"/>
                  <a:chExt cx="348916" cy="808255"/>
                </a:xfrm>
              </p:grpSpPr>
              <p:sp>
                <p:nvSpPr>
                  <p:cNvPr id="324" name="Trapezoid 323"/>
                  <p:cNvSpPr/>
                  <p:nvPr/>
                </p:nvSpPr>
                <p:spPr>
                  <a:xfrm rot="10800000">
                    <a:off x="4728410" y="2129588"/>
                    <a:ext cx="348916" cy="324853"/>
                  </a:xfrm>
                  <a:prstGeom prst="trapezoid">
                    <a:avLst>
                      <a:gd name="adj" fmla="val 26580"/>
                    </a:avLst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5" name="Freeform 324"/>
                  <p:cNvSpPr/>
                  <p:nvPr/>
                </p:nvSpPr>
                <p:spPr>
                  <a:xfrm>
                    <a:off x="4860760" y="1708483"/>
                    <a:ext cx="84220" cy="559468"/>
                  </a:xfrm>
                  <a:custGeom>
                    <a:avLst/>
                    <a:gdLst>
                      <a:gd name="connsiteX0" fmla="*/ 36699 w 120921"/>
                      <a:gd name="connsiteY0" fmla="*/ 1022685 h 1022685"/>
                      <a:gd name="connsiteX1" fmla="*/ 72794 w 120921"/>
                      <a:gd name="connsiteY1" fmla="*/ 685800 h 1022685"/>
                      <a:gd name="connsiteX2" fmla="*/ 605 w 120921"/>
                      <a:gd name="connsiteY2" fmla="*/ 288758 h 1022685"/>
                      <a:gd name="connsiteX3" fmla="*/ 120921 w 120921"/>
                      <a:gd name="connsiteY3" fmla="*/ 0 h 102268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20921" h="1022685">
                        <a:moveTo>
                          <a:pt x="36699" y="1022685"/>
                        </a:moveTo>
                        <a:cubicBezTo>
                          <a:pt x="57754" y="915403"/>
                          <a:pt x="78810" y="808121"/>
                          <a:pt x="72794" y="685800"/>
                        </a:cubicBezTo>
                        <a:cubicBezTo>
                          <a:pt x="66778" y="563479"/>
                          <a:pt x="-7416" y="403058"/>
                          <a:pt x="605" y="288758"/>
                        </a:cubicBezTo>
                        <a:cubicBezTo>
                          <a:pt x="8626" y="174458"/>
                          <a:pt x="102874" y="54142"/>
                          <a:pt x="120921" y="0"/>
                        </a:cubicBezTo>
                      </a:path>
                    </a:pathLst>
                  </a:custGeom>
                  <a:noFill/>
                  <a:ln>
                    <a:solidFill>
                      <a:srgbClr val="00B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6" name="Oval 325"/>
                  <p:cNvSpPr/>
                  <p:nvPr/>
                </p:nvSpPr>
                <p:spPr>
                  <a:xfrm rot="2661292" flipH="1">
                    <a:off x="4862109" y="1665564"/>
                    <a:ext cx="89204" cy="45719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7" name="Oval 326"/>
                  <p:cNvSpPr/>
                  <p:nvPr/>
                </p:nvSpPr>
                <p:spPr>
                  <a:xfrm rot="2060320" flipV="1">
                    <a:off x="4921067" y="1921042"/>
                    <a:ext cx="59461" cy="129716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8" name="Oval 327"/>
                  <p:cNvSpPr/>
                  <p:nvPr/>
                </p:nvSpPr>
                <p:spPr>
                  <a:xfrm rot="1383139">
                    <a:off x="4736678" y="1826313"/>
                    <a:ext cx="125950" cy="77157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9" name="Oval 328"/>
                  <p:cNvSpPr/>
                  <p:nvPr/>
                </p:nvSpPr>
                <p:spPr>
                  <a:xfrm rot="19895792" flipH="1">
                    <a:off x="4934175" y="1646186"/>
                    <a:ext cx="116962" cy="76970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10" name="Group 309"/>
                <p:cNvGrpSpPr/>
                <p:nvPr/>
              </p:nvGrpSpPr>
              <p:grpSpPr>
                <a:xfrm>
                  <a:off x="4851385" y="910972"/>
                  <a:ext cx="141343" cy="330765"/>
                  <a:chOff x="4728410" y="1646186"/>
                  <a:chExt cx="348916" cy="808255"/>
                </a:xfrm>
              </p:grpSpPr>
              <p:sp>
                <p:nvSpPr>
                  <p:cNvPr id="318" name="Trapezoid 317"/>
                  <p:cNvSpPr/>
                  <p:nvPr/>
                </p:nvSpPr>
                <p:spPr>
                  <a:xfrm rot="10800000">
                    <a:off x="4728410" y="2129588"/>
                    <a:ext cx="348916" cy="324853"/>
                  </a:xfrm>
                  <a:prstGeom prst="trapezoid">
                    <a:avLst>
                      <a:gd name="adj" fmla="val 26580"/>
                    </a:avLst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9" name="Freeform 318"/>
                  <p:cNvSpPr/>
                  <p:nvPr/>
                </p:nvSpPr>
                <p:spPr>
                  <a:xfrm>
                    <a:off x="4860760" y="1708483"/>
                    <a:ext cx="84220" cy="559468"/>
                  </a:xfrm>
                  <a:custGeom>
                    <a:avLst/>
                    <a:gdLst>
                      <a:gd name="connsiteX0" fmla="*/ 36699 w 120921"/>
                      <a:gd name="connsiteY0" fmla="*/ 1022685 h 1022685"/>
                      <a:gd name="connsiteX1" fmla="*/ 72794 w 120921"/>
                      <a:gd name="connsiteY1" fmla="*/ 685800 h 1022685"/>
                      <a:gd name="connsiteX2" fmla="*/ 605 w 120921"/>
                      <a:gd name="connsiteY2" fmla="*/ 288758 h 1022685"/>
                      <a:gd name="connsiteX3" fmla="*/ 120921 w 120921"/>
                      <a:gd name="connsiteY3" fmla="*/ 0 h 102268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20921" h="1022685">
                        <a:moveTo>
                          <a:pt x="36699" y="1022685"/>
                        </a:moveTo>
                        <a:cubicBezTo>
                          <a:pt x="57754" y="915403"/>
                          <a:pt x="78810" y="808121"/>
                          <a:pt x="72794" y="685800"/>
                        </a:cubicBezTo>
                        <a:cubicBezTo>
                          <a:pt x="66778" y="563479"/>
                          <a:pt x="-7416" y="403058"/>
                          <a:pt x="605" y="288758"/>
                        </a:cubicBezTo>
                        <a:cubicBezTo>
                          <a:pt x="8626" y="174458"/>
                          <a:pt x="102874" y="54142"/>
                          <a:pt x="120921" y="0"/>
                        </a:cubicBezTo>
                      </a:path>
                    </a:pathLst>
                  </a:custGeom>
                  <a:noFill/>
                  <a:ln>
                    <a:solidFill>
                      <a:srgbClr val="00B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0" name="Oval 319"/>
                  <p:cNvSpPr/>
                  <p:nvPr/>
                </p:nvSpPr>
                <p:spPr>
                  <a:xfrm rot="2661292" flipH="1">
                    <a:off x="4862109" y="1665564"/>
                    <a:ext cx="89204" cy="45719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1" name="Oval 320"/>
                  <p:cNvSpPr/>
                  <p:nvPr/>
                </p:nvSpPr>
                <p:spPr>
                  <a:xfrm rot="2060320" flipV="1">
                    <a:off x="4921067" y="1921042"/>
                    <a:ext cx="59461" cy="129716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2" name="Oval 321"/>
                  <p:cNvSpPr/>
                  <p:nvPr/>
                </p:nvSpPr>
                <p:spPr>
                  <a:xfrm rot="1383139">
                    <a:off x="4736678" y="1826313"/>
                    <a:ext cx="125950" cy="77157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3" name="Oval 322"/>
                  <p:cNvSpPr/>
                  <p:nvPr/>
                </p:nvSpPr>
                <p:spPr>
                  <a:xfrm rot="19895792" flipH="1">
                    <a:off x="4934175" y="1646186"/>
                    <a:ext cx="116962" cy="76970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11" name="Group 310"/>
                <p:cNvGrpSpPr/>
                <p:nvPr/>
              </p:nvGrpSpPr>
              <p:grpSpPr>
                <a:xfrm>
                  <a:off x="5045625" y="914661"/>
                  <a:ext cx="141343" cy="330765"/>
                  <a:chOff x="4728410" y="1646186"/>
                  <a:chExt cx="348916" cy="808255"/>
                </a:xfrm>
              </p:grpSpPr>
              <p:sp>
                <p:nvSpPr>
                  <p:cNvPr id="312" name="Trapezoid 311"/>
                  <p:cNvSpPr/>
                  <p:nvPr/>
                </p:nvSpPr>
                <p:spPr>
                  <a:xfrm rot="10800000">
                    <a:off x="4728410" y="2129588"/>
                    <a:ext cx="348916" cy="324853"/>
                  </a:xfrm>
                  <a:prstGeom prst="trapezoid">
                    <a:avLst>
                      <a:gd name="adj" fmla="val 26580"/>
                    </a:avLst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3" name="Freeform 312"/>
                  <p:cNvSpPr/>
                  <p:nvPr/>
                </p:nvSpPr>
                <p:spPr>
                  <a:xfrm>
                    <a:off x="4860760" y="1708483"/>
                    <a:ext cx="84220" cy="559468"/>
                  </a:xfrm>
                  <a:custGeom>
                    <a:avLst/>
                    <a:gdLst>
                      <a:gd name="connsiteX0" fmla="*/ 36699 w 120921"/>
                      <a:gd name="connsiteY0" fmla="*/ 1022685 h 1022685"/>
                      <a:gd name="connsiteX1" fmla="*/ 72794 w 120921"/>
                      <a:gd name="connsiteY1" fmla="*/ 685800 h 1022685"/>
                      <a:gd name="connsiteX2" fmla="*/ 605 w 120921"/>
                      <a:gd name="connsiteY2" fmla="*/ 288758 h 1022685"/>
                      <a:gd name="connsiteX3" fmla="*/ 120921 w 120921"/>
                      <a:gd name="connsiteY3" fmla="*/ 0 h 102268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20921" h="1022685">
                        <a:moveTo>
                          <a:pt x="36699" y="1022685"/>
                        </a:moveTo>
                        <a:cubicBezTo>
                          <a:pt x="57754" y="915403"/>
                          <a:pt x="78810" y="808121"/>
                          <a:pt x="72794" y="685800"/>
                        </a:cubicBezTo>
                        <a:cubicBezTo>
                          <a:pt x="66778" y="563479"/>
                          <a:pt x="-7416" y="403058"/>
                          <a:pt x="605" y="288758"/>
                        </a:cubicBezTo>
                        <a:cubicBezTo>
                          <a:pt x="8626" y="174458"/>
                          <a:pt x="102874" y="54142"/>
                          <a:pt x="120921" y="0"/>
                        </a:cubicBezTo>
                      </a:path>
                    </a:pathLst>
                  </a:custGeom>
                  <a:noFill/>
                  <a:ln>
                    <a:solidFill>
                      <a:srgbClr val="00B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4" name="Oval 313"/>
                  <p:cNvSpPr/>
                  <p:nvPr/>
                </p:nvSpPr>
                <p:spPr>
                  <a:xfrm rot="2661292" flipH="1">
                    <a:off x="4862109" y="1665564"/>
                    <a:ext cx="89204" cy="45719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5" name="Oval 314"/>
                  <p:cNvSpPr/>
                  <p:nvPr/>
                </p:nvSpPr>
                <p:spPr>
                  <a:xfrm rot="2060320" flipV="1">
                    <a:off x="4921067" y="1921042"/>
                    <a:ext cx="59461" cy="129716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6" name="Oval 315"/>
                  <p:cNvSpPr/>
                  <p:nvPr/>
                </p:nvSpPr>
                <p:spPr>
                  <a:xfrm rot="1383139">
                    <a:off x="4736678" y="1826313"/>
                    <a:ext cx="125950" cy="77157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7" name="Oval 316"/>
                  <p:cNvSpPr/>
                  <p:nvPr/>
                </p:nvSpPr>
                <p:spPr>
                  <a:xfrm rot="19895792" flipH="1">
                    <a:off x="4934175" y="1646186"/>
                    <a:ext cx="116962" cy="76970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</p:grpSp>
      <p:grpSp>
        <p:nvGrpSpPr>
          <p:cNvPr id="359" name="Group 358"/>
          <p:cNvGrpSpPr/>
          <p:nvPr/>
        </p:nvGrpSpPr>
        <p:grpSpPr>
          <a:xfrm>
            <a:off x="8060014" y="1086843"/>
            <a:ext cx="3268106" cy="1800493"/>
            <a:chOff x="1609047" y="1000125"/>
            <a:chExt cx="3268106" cy="1800493"/>
          </a:xfrm>
        </p:grpSpPr>
        <p:sp>
          <p:nvSpPr>
            <p:cNvPr id="360" name="TextBox 359"/>
            <p:cNvSpPr txBox="1"/>
            <p:nvPr/>
          </p:nvSpPr>
          <p:spPr>
            <a:xfrm>
              <a:off x="1609047" y="1000125"/>
              <a:ext cx="3268106" cy="1800493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100" b="1" dirty="0" smtClean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Bio-Rep3</a:t>
              </a:r>
            </a:p>
            <a:p>
              <a:endPara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1" name="TextBox 360"/>
            <p:cNvSpPr txBox="1"/>
            <p:nvPr/>
          </p:nvSpPr>
          <p:spPr>
            <a:xfrm>
              <a:off x="1675376" y="2339117"/>
              <a:ext cx="681111" cy="369332"/>
            </a:xfrm>
            <a:prstGeom prst="rect">
              <a:avLst/>
            </a:prstGeom>
            <a:solidFill>
              <a:srgbClr val="00B050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2" name="TextBox 361"/>
            <p:cNvSpPr txBox="1"/>
            <p:nvPr/>
          </p:nvSpPr>
          <p:spPr>
            <a:xfrm>
              <a:off x="2488355" y="2334126"/>
              <a:ext cx="655742" cy="369332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HL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63" name="Group 362"/>
            <p:cNvGrpSpPr/>
            <p:nvPr/>
          </p:nvGrpSpPr>
          <p:grpSpPr>
            <a:xfrm>
              <a:off x="1941095" y="2155600"/>
              <a:ext cx="916272" cy="153276"/>
              <a:chOff x="1519251" y="2750034"/>
              <a:chExt cx="7140779" cy="491086"/>
            </a:xfrm>
          </p:grpSpPr>
          <p:cxnSp>
            <p:nvCxnSpPr>
              <p:cNvPr id="418" name="Straight Connector 417"/>
              <p:cNvCxnSpPr/>
              <p:nvPr/>
            </p:nvCxnSpPr>
            <p:spPr>
              <a:xfrm>
                <a:off x="1519251" y="2750034"/>
                <a:ext cx="7126715" cy="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9" name="Straight Connector 418"/>
              <p:cNvCxnSpPr/>
              <p:nvPr/>
            </p:nvCxnSpPr>
            <p:spPr>
              <a:xfrm>
                <a:off x="1535141" y="2750526"/>
                <a:ext cx="0" cy="490594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20" name="Straight Connector 419"/>
              <p:cNvCxnSpPr/>
              <p:nvPr/>
            </p:nvCxnSpPr>
            <p:spPr>
              <a:xfrm>
                <a:off x="8660030" y="2750034"/>
                <a:ext cx="0" cy="490594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64" name="Group 363"/>
            <p:cNvGrpSpPr/>
            <p:nvPr/>
          </p:nvGrpSpPr>
          <p:grpSpPr>
            <a:xfrm>
              <a:off x="1945710" y="1484372"/>
              <a:ext cx="894523" cy="644824"/>
              <a:chOff x="2040643" y="1186739"/>
              <a:chExt cx="894523" cy="644824"/>
            </a:xfrm>
          </p:grpSpPr>
          <p:sp>
            <p:nvSpPr>
              <p:cNvPr id="395" name="TextBox 394"/>
              <p:cNvSpPr txBox="1"/>
              <p:nvPr/>
            </p:nvSpPr>
            <p:spPr>
              <a:xfrm>
                <a:off x="2040643" y="1186739"/>
                <a:ext cx="89452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lang="zh-CN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96" name="Group 395"/>
              <p:cNvGrpSpPr/>
              <p:nvPr/>
            </p:nvGrpSpPr>
            <p:grpSpPr>
              <a:xfrm>
                <a:off x="2193600" y="1497109"/>
                <a:ext cx="531040" cy="334454"/>
                <a:chOff x="4655928" y="910972"/>
                <a:chExt cx="531040" cy="334454"/>
              </a:xfrm>
            </p:grpSpPr>
            <p:grpSp>
              <p:nvGrpSpPr>
                <p:cNvPr id="397" name="Group 396"/>
                <p:cNvGrpSpPr/>
                <p:nvPr/>
              </p:nvGrpSpPr>
              <p:grpSpPr>
                <a:xfrm>
                  <a:off x="4655928" y="912312"/>
                  <a:ext cx="141343" cy="330765"/>
                  <a:chOff x="4728410" y="1646186"/>
                  <a:chExt cx="348916" cy="808255"/>
                </a:xfrm>
              </p:grpSpPr>
              <p:sp>
                <p:nvSpPr>
                  <p:cNvPr id="412" name="Trapezoid 411"/>
                  <p:cNvSpPr/>
                  <p:nvPr/>
                </p:nvSpPr>
                <p:spPr>
                  <a:xfrm rot="10800000">
                    <a:off x="4728410" y="2129588"/>
                    <a:ext cx="348916" cy="324853"/>
                  </a:xfrm>
                  <a:prstGeom prst="trapezoid">
                    <a:avLst>
                      <a:gd name="adj" fmla="val 26580"/>
                    </a:avLst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3" name="Freeform 412"/>
                  <p:cNvSpPr/>
                  <p:nvPr/>
                </p:nvSpPr>
                <p:spPr>
                  <a:xfrm>
                    <a:off x="4860760" y="1708483"/>
                    <a:ext cx="84220" cy="559468"/>
                  </a:xfrm>
                  <a:custGeom>
                    <a:avLst/>
                    <a:gdLst>
                      <a:gd name="connsiteX0" fmla="*/ 36699 w 120921"/>
                      <a:gd name="connsiteY0" fmla="*/ 1022685 h 1022685"/>
                      <a:gd name="connsiteX1" fmla="*/ 72794 w 120921"/>
                      <a:gd name="connsiteY1" fmla="*/ 685800 h 1022685"/>
                      <a:gd name="connsiteX2" fmla="*/ 605 w 120921"/>
                      <a:gd name="connsiteY2" fmla="*/ 288758 h 1022685"/>
                      <a:gd name="connsiteX3" fmla="*/ 120921 w 120921"/>
                      <a:gd name="connsiteY3" fmla="*/ 0 h 102268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20921" h="1022685">
                        <a:moveTo>
                          <a:pt x="36699" y="1022685"/>
                        </a:moveTo>
                        <a:cubicBezTo>
                          <a:pt x="57754" y="915403"/>
                          <a:pt x="78810" y="808121"/>
                          <a:pt x="72794" y="685800"/>
                        </a:cubicBezTo>
                        <a:cubicBezTo>
                          <a:pt x="66778" y="563479"/>
                          <a:pt x="-7416" y="403058"/>
                          <a:pt x="605" y="288758"/>
                        </a:cubicBezTo>
                        <a:cubicBezTo>
                          <a:pt x="8626" y="174458"/>
                          <a:pt x="102874" y="54142"/>
                          <a:pt x="120921" y="0"/>
                        </a:cubicBezTo>
                      </a:path>
                    </a:pathLst>
                  </a:custGeom>
                  <a:noFill/>
                  <a:ln>
                    <a:solidFill>
                      <a:srgbClr val="00B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4" name="Oval 413"/>
                  <p:cNvSpPr/>
                  <p:nvPr/>
                </p:nvSpPr>
                <p:spPr>
                  <a:xfrm rot="2661292" flipH="1">
                    <a:off x="4862109" y="1665564"/>
                    <a:ext cx="89204" cy="45719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5" name="Oval 414"/>
                  <p:cNvSpPr/>
                  <p:nvPr/>
                </p:nvSpPr>
                <p:spPr>
                  <a:xfrm rot="2060320" flipV="1">
                    <a:off x="4921067" y="1921042"/>
                    <a:ext cx="59461" cy="129716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6" name="Oval 415"/>
                  <p:cNvSpPr/>
                  <p:nvPr/>
                </p:nvSpPr>
                <p:spPr>
                  <a:xfrm rot="1383139">
                    <a:off x="4736678" y="1826313"/>
                    <a:ext cx="125950" cy="77157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7" name="Oval 416"/>
                  <p:cNvSpPr/>
                  <p:nvPr/>
                </p:nvSpPr>
                <p:spPr>
                  <a:xfrm rot="19895792" flipH="1">
                    <a:off x="4934175" y="1646186"/>
                    <a:ext cx="116962" cy="76970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98" name="Group 397"/>
                <p:cNvGrpSpPr/>
                <p:nvPr/>
              </p:nvGrpSpPr>
              <p:grpSpPr>
                <a:xfrm>
                  <a:off x="4851385" y="910972"/>
                  <a:ext cx="141343" cy="330765"/>
                  <a:chOff x="4728410" y="1646186"/>
                  <a:chExt cx="348916" cy="808255"/>
                </a:xfrm>
              </p:grpSpPr>
              <p:sp>
                <p:nvSpPr>
                  <p:cNvPr id="406" name="Trapezoid 405"/>
                  <p:cNvSpPr/>
                  <p:nvPr/>
                </p:nvSpPr>
                <p:spPr>
                  <a:xfrm rot="10800000">
                    <a:off x="4728410" y="2129588"/>
                    <a:ext cx="348916" cy="324853"/>
                  </a:xfrm>
                  <a:prstGeom prst="trapezoid">
                    <a:avLst>
                      <a:gd name="adj" fmla="val 26580"/>
                    </a:avLst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7" name="Freeform 406"/>
                  <p:cNvSpPr/>
                  <p:nvPr/>
                </p:nvSpPr>
                <p:spPr>
                  <a:xfrm>
                    <a:off x="4860760" y="1708483"/>
                    <a:ext cx="84220" cy="559468"/>
                  </a:xfrm>
                  <a:custGeom>
                    <a:avLst/>
                    <a:gdLst>
                      <a:gd name="connsiteX0" fmla="*/ 36699 w 120921"/>
                      <a:gd name="connsiteY0" fmla="*/ 1022685 h 1022685"/>
                      <a:gd name="connsiteX1" fmla="*/ 72794 w 120921"/>
                      <a:gd name="connsiteY1" fmla="*/ 685800 h 1022685"/>
                      <a:gd name="connsiteX2" fmla="*/ 605 w 120921"/>
                      <a:gd name="connsiteY2" fmla="*/ 288758 h 1022685"/>
                      <a:gd name="connsiteX3" fmla="*/ 120921 w 120921"/>
                      <a:gd name="connsiteY3" fmla="*/ 0 h 102268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20921" h="1022685">
                        <a:moveTo>
                          <a:pt x="36699" y="1022685"/>
                        </a:moveTo>
                        <a:cubicBezTo>
                          <a:pt x="57754" y="915403"/>
                          <a:pt x="78810" y="808121"/>
                          <a:pt x="72794" y="685800"/>
                        </a:cubicBezTo>
                        <a:cubicBezTo>
                          <a:pt x="66778" y="563479"/>
                          <a:pt x="-7416" y="403058"/>
                          <a:pt x="605" y="288758"/>
                        </a:cubicBezTo>
                        <a:cubicBezTo>
                          <a:pt x="8626" y="174458"/>
                          <a:pt x="102874" y="54142"/>
                          <a:pt x="120921" y="0"/>
                        </a:cubicBezTo>
                      </a:path>
                    </a:pathLst>
                  </a:custGeom>
                  <a:noFill/>
                  <a:ln>
                    <a:solidFill>
                      <a:srgbClr val="00B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8" name="Oval 407"/>
                  <p:cNvSpPr/>
                  <p:nvPr/>
                </p:nvSpPr>
                <p:spPr>
                  <a:xfrm rot="2661292" flipH="1">
                    <a:off x="4862109" y="1665564"/>
                    <a:ext cx="89204" cy="45719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9" name="Oval 408"/>
                  <p:cNvSpPr/>
                  <p:nvPr/>
                </p:nvSpPr>
                <p:spPr>
                  <a:xfrm rot="2060320" flipV="1">
                    <a:off x="4921067" y="1921042"/>
                    <a:ext cx="59461" cy="129716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0" name="Oval 409"/>
                  <p:cNvSpPr/>
                  <p:nvPr/>
                </p:nvSpPr>
                <p:spPr>
                  <a:xfrm rot="1383139">
                    <a:off x="4736678" y="1826313"/>
                    <a:ext cx="125950" cy="77157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1" name="Oval 410"/>
                  <p:cNvSpPr/>
                  <p:nvPr/>
                </p:nvSpPr>
                <p:spPr>
                  <a:xfrm rot="19895792" flipH="1">
                    <a:off x="4934175" y="1646186"/>
                    <a:ext cx="116962" cy="76970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99" name="Group 398"/>
                <p:cNvGrpSpPr/>
                <p:nvPr/>
              </p:nvGrpSpPr>
              <p:grpSpPr>
                <a:xfrm>
                  <a:off x="5045625" y="914661"/>
                  <a:ext cx="141343" cy="330765"/>
                  <a:chOff x="4728410" y="1646186"/>
                  <a:chExt cx="348916" cy="808255"/>
                </a:xfrm>
              </p:grpSpPr>
              <p:sp>
                <p:nvSpPr>
                  <p:cNvPr id="400" name="Trapezoid 399"/>
                  <p:cNvSpPr/>
                  <p:nvPr/>
                </p:nvSpPr>
                <p:spPr>
                  <a:xfrm rot="10800000">
                    <a:off x="4728410" y="2129588"/>
                    <a:ext cx="348916" cy="324853"/>
                  </a:xfrm>
                  <a:prstGeom prst="trapezoid">
                    <a:avLst>
                      <a:gd name="adj" fmla="val 26580"/>
                    </a:avLst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1" name="Freeform 400"/>
                  <p:cNvSpPr/>
                  <p:nvPr/>
                </p:nvSpPr>
                <p:spPr>
                  <a:xfrm>
                    <a:off x="4860760" y="1708483"/>
                    <a:ext cx="84220" cy="559468"/>
                  </a:xfrm>
                  <a:custGeom>
                    <a:avLst/>
                    <a:gdLst>
                      <a:gd name="connsiteX0" fmla="*/ 36699 w 120921"/>
                      <a:gd name="connsiteY0" fmla="*/ 1022685 h 1022685"/>
                      <a:gd name="connsiteX1" fmla="*/ 72794 w 120921"/>
                      <a:gd name="connsiteY1" fmla="*/ 685800 h 1022685"/>
                      <a:gd name="connsiteX2" fmla="*/ 605 w 120921"/>
                      <a:gd name="connsiteY2" fmla="*/ 288758 h 1022685"/>
                      <a:gd name="connsiteX3" fmla="*/ 120921 w 120921"/>
                      <a:gd name="connsiteY3" fmla="*/ 0 h 102268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20921" h="1022685">
                        <a:moveTo>
                          <a:pt x="36699" y="1022685"/>
                        </a:moveTo>
                        <a:cubicBezTo>
                          <a:pt x="57754" y="915403"/>
                          <a:pt x="78810" y="808121"/>
                          <a:pt x="72794" y="685800"/>
                        </a:cubicBezTo>
                        <a:cubicBezTo>
                          <a:pt x="66778" y="563479"/>
                          <a:pt x="-7416" y="403058"/>
                          <a:pt x="605" y="288758"/>
                        </a:cubicBezTo>
                        <a:cubicBezTo>
                          <a:pt x="8626" y="174458"/>
                          <a:pt x="102874" y="54142"/>
                          <a:pt x="120921" y="0"/>
                        </a:cubicBezTo>
                      </a:path>
                    </a:pathLst>
                  </a:custGeom>
                  <a:noFill/>
                  <a:ln>
                    <a:solidFill>
                      <a:srgbClr val="00B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2" name="Oval 401"/>
                  <p:cNvSpPr/>
                  <p:nvPr/>
                </p:nvSpPr>
                <p:spPr>
                  <a:xfrm rot="2661292" flipH="1">
                    <a:off x="4862109" y="1665564"/>
                    <a:ext cx="89204" cy="45719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3" name="Oval 402"/>
                  <p:cNvSpPr/>
                  <p:nvPr/>
                </p:nvSpPr>
                <p:spPr>
                  <a:xfrm rot="2060320" flipV="1">
                    <a:off x="4921067" y="1921042"/>
                    <a:ext cx="59461" cy="129716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4" name="Oval 403"/>
                  <p:cNvSpPr/>
                  <p:nvPr/>
                </p:nvSpPr>
                <p:spPr>
                  <a:xfrm rot="1383139">
                    <a:off x="4736678" y="1826313"/>
                    <a:ext cx="125950" cy="77157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5" name="Oval 404"/>
                  <p:cNvSpPr/>
                  <p:nvPr/>
                </p:nvSpPr>
                <p:spPr>
                  <a:xfrm rot="19895792" flipH="1">
                    <a:off x="4934175" y="1646186"/>
                    <a:ext cx="116962" cy="76970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sp>
          <p:nvSpPr>
            <p:cNvPr id="365" name="TextBox 364"/>
            <p:cNvSpPr txBox="1"/>
            <p:nvPr/>
          </p:nvSpPr>
          <p:spPr>
            <a:xfrm>
              <a:off x="3350421" y="2328856"/>
              <a:ext cx="681111" cy="369332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6" name="TextBox 365"/>
            <p:cNvSpPr txBox="1"/>
            <p:nvPr/>
          </p:nvSpPr>
          <p:spPr>
            <a:xfrm>
              <a:off x="4163400" y="2323865"/>
              <a:ext cx="655742" cy="369332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HL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67" name="Group 366"/>
            <p:cNvGrpSpPr/>
            <p:nvPr/>
          </p:nvGrpSpPr>
          <p:grpSpPr>
            <a:xfrm>
              <a:off x="3616140" y="2145339"/>
              <a:ext cx="916272" cy="153276"/>
              <a:chOff x="1519251" y="2750034"/>
              <a:chExt cx="7140779" cy="491086"/>
            </a:xfrm>
          </p:grpSpPr>
          <p:cxnSp>
            <p:nvCxnSpPr>
              <p:cNvPr id="392" name="Straight Connector 391"/>
              <p:cNvCxnSpPr/>
              <p:nvPr/>
            </p:nvCxnSpPr>
            <p:spPr>
              <a:xfrm>
                <a:off x="1519251" y="2750034"/>
                <a:ext cx="7126715" cy="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3" name="Straight Connector 392"/>
              <p:cNvCxnSpPr/>
              <p:nvPr/>
            </p:nvCxnSpPr>
            <p:spPr>
              <a:xfrm>
                <a:off x="1535141" y="2750526"/>
                <a:ext cx="0" cy="490594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4" name="Straight Connector 393"/>
              <p:cNvCxnSpPr/>
              <p:nvPr/>
            </p:nvCxnSpPr>
            <p:spPr>
              <a:xfrm>
                <a:off x="8660030" y="2750034"/>
                <a:ext cx="0" cy="490594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68" name="Group 367"/>
            <p:cNvGrpSpPr/>
            <p:nvPr/>
          </p:nvGrpSpPr>
          <p:grpSpPr>
            <a:xfrm>
              <a:off x="3658856" y="1474111"/>
              <a:ext cx="760684" cy="644824"/>
              <a:chOff x="2078744" y="1186739"/>
              <a:chExt cx="760684" cy="644824"/>
            </a:xfrm>
          </p:grpSpPr>
          <p:sp>
            <p:nvSpPr>
              <p:cNvPr id="369" name="TextBox 368"/>
              <p:cNvSpPr txBox="1"/>
              <p:nvPr/>
            </p:nvSpPr>
            <p:spPr>
              <a:xfrm>
                <a:off x="2078744" y="1186739"/>
                <a:ext cx="76068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SV</a:t>
                </a:r>
                <a:endParaRPr lang="zh-CN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70" name="Group 369"/>
              <p:cNvGrpSpPr/>
              <p:nvPr/>
            </p:nvGrpSpPr>
            <p:grpSpPr>
              <a:xfrm>
                <a:off x="2193600" y="1497109"/>
                <a:ext cx="531040" cy="334454"/>
                <a:chOff x="4655928" y="910972"/>
                <a:chExt cx="531040" cy="334454"/>
              </a:xfrm>
            </p:grpSpPr>
            <p:grpSp>
              <p:nvGrpSpPr>
                <p:cNvPr id="371" name="Group 370"/>
                <p:cNvGrpSpPr/>
                <p:nvPr/>
              </p:nvGrpSpPr>
              <p:grpSpPr>
                <a:xfrm>
                  <a:off x="4655928" y="912312"/>
                  <a:ext cx="141343" cy="330765"/>
                  <a:chOff x="4728410" y="1646186"/>
                  <a:chExt cx="348916" cy="808255"/>
                </a:xfrm>
              </p:grpSpPr>
              <p:sp>
                <p:nvSpPr>
                  <p:cNvPr id="386" name="Trapezoid 385"/>
                  <p:cNvSpPr/>
                  <p:nvPr/>
                </p:nvSpPr>
                <p:spPr>
                  <a:xfrm rot="10800000">
                    <a:off x="4728410" y="2129588"/>
                    <a:ext cx="348916" cy="324853"/>
                  </a:xfrm>
                  <a:prstGeom prst="trapezoid">
                    <a:avLst>
                      <a:gd name="adj" fmla="val 26580"/>
                    </a:avLst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7" name="Freeform 386"/>
                  <p:cNvSpPr/>
                  <p:nvPr/>
                </p:nvSpPr>
                <p:spPr>
                  <a:xfrm>
                    <a:off x="4860760" y="1708483"/>
                    <a:ext cx="84220" cy="559468"/>
                  </a:xfrm>
                  <a:custGeom>
                    <a:avLst/>
                    <a:gdLst>
                      <a:gd name="connsiteX0" fmla="*/ 36699 w 120921"/>
                      <a:gd name="connsiteY0" fmla="*/ 1022685 h 1022685"/>
                      <a:gd name="connsiteX1" fmla="*/ 72794 w 120921"/>
                      <a:gd name="connsiteY1" fmla="*/ 685800 h 1022685"/>
                      <a:gd name="connsiteX2" fmla="*/ 605 w 120921"/>
                      <a:gd name="connsiteY2" fmla="*/ 288758 h 1022685"/>
                      <a:gd name="connsiteX3" fmla="*/ 120921 w 120921"/>
                      <a:gd name="connsiteY3" fmla="*/ 0 h 102268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20921" h="1022685">
                        <a:moveTo>
                          <a:pt x="36699" y="1022685"/>
                        </a:moveTo>
                        <a:cubicBezTo>
                          <a:pt x="57754" y="915403"/>
                          <a:pt x="78810" y="808121"/>
                          <a:pt x="72794" y="685800"/>
                        </a:cubicBezTo>
                        <a:cubicBezTo>
                          <a:pt x="66778" y="563479"/>
                          <a:pt x="-7416" y="403058"/>
                          <a:pt x="605" y="288758"/>
                        </a:cubicBezTo>
                        <a:cubicBezTo>
                          <a:pt x="8626" y="174458"/>
                          <a:pt x="102874" y="54142"/>
                          <a:pt x="120921" y="0"/>
                        </a:cubicBezTo>
                      </a:path>
                    </a:pathLst>
                  </a:custGeom>
                  <a:noFill/>
                  <a:ln>
                    <a:solidFill>
                      <a:srgbClr val="00B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8" name="Oval 387"/>
                  <p:cNvSpPr/>
                  <p:nvPr/>
                </p:nvSpPr>
                <p:spPr>
                  <a:xfrm rot="2661292" flipH="1">
                    <a:off x="4862109" y="1665564"/>
                    <a:ext cx="89204" cy="45719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9" name="Oval 388"/>
                  <p:cNvSpPr/>
                  <p:nvPr/>
                </p:nvSpPr>
                <p:spPr>
                  <a:xfrm rot="2060320" flipV="1">
                    <a:off x="4921067" y="1921042"/>
                    <a:ext cx="59461" cy="129716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0" name="Oval 389"/>
                  <p:cNvSpPr/>
                  <p:nvPr/>
                </p:nvSpPr>
                <p:spPr>
                  <a:xfrm rot="1383139">
                    <a:off x="4736678" y="1826313"/>
                    <a:ext cx="125950" cy="77157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1" name="Oval 390"/>
                  <p:cNvSpPr/>
                  <p:nvPr/>
                </p:nvSpPr>
                <p:spPr>
                  <a:xfrm rot="19895792" flipH="1">
                    <a:off x="4934175" y="1646186"/>
                    <a:ext cx="116962" cy="76970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72" name="Group 371"/>
                <p:cNvGrpSpPr/>
                <p:nvPr/>
              </p:nvGrpSpPr>
              <p:grpSpPr>
                <a:xfrm>
                  <a:off x="4851385" y="910972"/>
                  <a:ext cx="141343" cy="330765"/>
                  <a:chOff x="4728410" y="1646186"/>
                  <a:chExt cx="348916" cy="808255"/>
                </a:xfrm>
              </p:grpSpPr>
              <p:sp>
                <p:nvSpPr>
                  <p:cNvPr id="380" name="Trapezoid 379"/>
                  <p:cNvSpPr/>
                  <p:nvPr/>
                </p:nvSpPr>
                <p:spPr>
                  <a:xfrm rot="10800000">
                    <a:off x="4728410" y="2129588"/>
                    <a:ext cx="348916" cy="324853"/>
                  </a:xfrm>
                  <a:prstGeom prst="trapezoid">
                    <a:avLst>
                      <a:gd name="adj" fmla="val 26580"/>
                    </a:avLst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1" name="Freeform 380"/>
                  <p:cNvSpPr/>
                  <p:nvPr/>
                </p:nvSpPr>
                <p:spPr>
                  <a:xfrm>
                    <a:off x="4860760" y="1708483"/>
                    <a:ext cx="84220" cy="559468"/>
                  </a:xfrm>
                  <a:custGeom>
                    <a:avLst/>
                    <a:gdLst>
                      <a:gd name="connsiteX0" fmla="*/ 36699 w 120921"/>
                      <a:gd name="connsiteY0" fmla="*/ 1022685 h 1022685"/>
                      <a:gd name="connsiteX1" fmla="*/ 72794 w 120921"/>
                      <a:gd name="connsiteY1" fmla="*/ 685800 h 1022685"/>
                      <a:gd name="connsiteX2" fmla="*/ 605 w 120921"/>
                      <a:gd name="connsiteY2" fmla="*/ 288758 h 1022685"/>
                      <a:gd name="connsiteX3" fmla="*/ 120921 w 120921"/>
                      <a:gd name="connsiteY3" fmla="*/ 0 h 102268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20921" h="1022685">
                        <a:moveTo>
                          <a:pt x="36699" y="1022685"/>
                        </a:moveTo>
                        <a:cubicBezTo>
                          <a:pt x="57754" y="915403"/>
                          <a:pt x="78810" y="808121"/>
                          <a:pt x="72794" y="685800"/>
                        </a:cubicBezTo>
                        <a:cubicBezTo>
                          <a:pt x="66778" y="563479"/>
                          <a:pt x="-7416" y="403058"/>
                          <a:pt x="605" y="288758"/>
                        </a:cubicBezTo>
                        <a:cubicBezTo>
                          <a:pt x="8626" y="174458"/>
                          <a:pt x="102874" y="54142"/>
                          <a:pt x="120921" y="0"/>
                        </a:cubicBezTo>
                      </a:path>
                    </a:pathLst>
                  </a:custGeom>
                  <a:noFill/>
                  <a:ln>
                    <a:solidFill>
                      <a:srgbClr val="00B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2" name="Oval 381"/>
                  <p:cNvSpPr/>
                  <p:nvPr/>
                </p:nvSpPr>
                <p:spPr>
                  <a:xfrm rot="2661292" flipH="1">
                    <a:off x="4862109" y="1665564"/>
                    <a:ext cx="89204" cy="45719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3" name="Oval 382"/>
                  <p:cNvSpPr/>
                  <p:nvPr/>
                </p:nvSpPr>
                <p:spPr>
                  <a:xfrm rot="2060320" flipV="1">
                    <a:off x="4921067" y="1921042"/>
                    <a:ext cx="59461" cy="129716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4" name="Oval 383"/>
                  <p:cNvSpPr/>
                  <p:nvPr/>
                </p:nvSpPr>
                <p:spPr>
                  <a:xfrm rot="1383139">
                    <a:off x="4736678" y="1826313"/>
                    <a:ext cx="125950" cy="77157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5" name="Oval 384"/>
                  <p:cNvSpPr/>
                  <p:nvPr/>
                </p:nvSpPr>
                <p:spPr>
                  <a:xfrm rot="19895792" flipH="1">
                    <a:off x="4934175" y="1646186"/>
                    <a:ext cx="116962" cy="76970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73" name="Group 372"/>
                <p:cNvGrpSpPr/>
                <p:nvPr/>
              </p:nvGrpSpPr>
              <p:grpSpPr>
                <a:xfrm>
                  <a:off x="5045625" y="914661"/>
                  <a:ext cx="141343" cy="330765"/>
                  <a:chOff x="4728410" y="1646186"/>
                  <a:chExt cx="348916" cy="808255"/>
                </a:xfrm>
              </p:grpSpPr>
              <p:sp>
                <p:nvSpPr>
                  <p:cNvPr id="374" name="Trapezoid 373"/>
                  <p:cNvSpPr/>
                  <p:nvPr/>
                </p:nvSpPr>
                <p:spPr>
                  <a:xfrm rot="10800000">
                    <a:off x="4728410" y="2129588"/>
                    <a:ext cx="348916" cy="324853"/>
                  </a:xfrm>
                  <a:prstGeom prst="trapezoid">
                    <a:avLst>
                      <a:gd name="adj" fmla="val 26580"/>
                    </a:avLst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5" name="Freeform 374"/>
                  <p:cNvSpPr/>
                  <p:nvPr/>
                </p:nvSpPr>
                <p:spPr>
                  <a:xfrm>
                    <a:off x="4860760" y="1708483"/>
                    <a:ext cx="84220" cy="559468"/>
                  </a:xfrm>
                  <a:custGeom>
                    <a:avLst/>
                    <a:gdLst>
                      <a:gd name="connsiteX0" fmla="*/ 36699 w 120921"/>
                      <a:gd name="connsiteY0" fmla="*/ 1022685 h 1022685"/>
                      <a:gd name="connsiteX1" fmla="*/ 72794 w 120921"/>
                      <a:gd name="connsiteY1" fmla="*/ 685800 h 1022685"/>
                      <a:gd name="connsiteX2" fmla="*/ 605 w 120921"/>
                      <a:gd name="connsiteY2" fmla="*/ 288758 h 1022685"/>
                      <a:gd name="connsiteX3" fmla="*/ 120921 w 120921"/>
                      <a:gd name="connsiteY3" fmla="*/ 0 h 102268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20921" h="1022685">
                        <a:moveTo>
                          <a:pt x="36699" y="1022685"/>
                        </a:moveTo>
                        <a:cubicBezTo>
                          <a:pt x="57754" y="915403"/>
                          <a:pt x="78810" y="808121"/>
                          <a:pt x="72794" y="685800"/>
                        </a:cubicBezTo>
                        <a:cubicBezTo>
                          <a:pt x="66778" y="563479"/>
                          <a:pt x="-7416" y="403058"/>
                          <a:pt x="605" y="288758"/>
                        </a:cubicBezTo>
                        <a:cubicBezTo>
                          <a:pt x="8626" y="174458"/>
                          <a:pt x="102874" y="54142"/>
                          <a:pt x="120921" y="0"/>
                        </a:cubicBezTo>
                      </a:path>
                    </a:pathLst>
                  </a:custGeom>
                  <a:noFill/>
                  <a:ln>
                    <a:solidFill>
                      <a:srgbClr val="00B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6" name="Oval 375"/>
                  <p:cNvSpPr/>
                  <p:nvPr/>
                </p:nvSpPr>
                <p:spPr>
                  <a:xfrm rot="2661292" flipH="1">
                    <a:off x="4862109" y="1665564"/>
                    <a:ext cx="89204" cy="45719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7" name="Oval 376"/>
                  <p:cNvSpPr/>
                  <p:nvPr/>
                </p:nvSpPr>
                <p:spPr>
                  <a:xfrm rot="2060320" flipV="1">
                    <a:off x="4921067" y="1921042"/>
                    <a:ext cx="59461" cy="129716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8" name="Oval 377"/>
                  <p:cNvSpPr/>
                  <p:nvPr/>
                </p:nvSpPr>
                <p:spPr>
                  <a:xfrm rot="1383139">
                    <a:off x="4736678" y="1826313"/>
                    <a:ext cx="125950" cy="77157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9" name="Oval 378"/>
                  <p:cNvSpPr/>
                  <p:nvPr/>
                </p:nvSpPr>
                <p:spPr>
                  <a:xfrm rot="19895792" flipH="1">
                    <a:off x="4934175" y="1646186"/>
                    <a:ext cx="116962" cy="76970"/>
                  </a:xfrm>
                  <a:prstGeom prst="ellips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</p:grpSp>
      <p:grpSp>
        <p:nvGrpSpPr>
          <p:cNvPr id="188" name="Group 187"/>
          <p:cNvGrpSpPr/>
          <p:nvPr/>
        </p:nvGrpSpPr>
        <p:grpSpPr>
          <a:xfrm>
            <a:off x="1388587" y="2810423"/>
            <a:ext cx="7089945" cy="810660"/>
            <a:chOff x="2084768" y="1899685"/>
            <a:chExt cx="6113401" cy="1204455"/>
          </a:xfrm>
        </p:grpSpPr>
        <p:grpSp>
          <p:nvGrpSpPr>
            <p:cNvPr id="189" name="Group 188"/>
            <p:cNvGrpSpPr/>
            <p:nvPr/>
          </p:nvGrpSpPr>
          <p:grpSpPr>
            <a:xfrm>
              <a:off x="2084768" y="1899685"/>
              <a:ext cx="6113401" cy="1204455"/>
              <a:chOff x="1523376" y="2757345"/>
              <a:chExt cx="7136654" cy="491086"/>
            </a:xfrm>
          </p:grpSpPr>
          <p:cxnSp>
            <p:nvCxnSpPr>
              <p:cNvPr id="191" name="Straight Connector 190"/>
              <p:cNvCxnSpPr/>
              <p:nvPr/>
            </p:nvCxnSpPr>
            <p:spPr>
              <a:xfrm>
                <a:off x="1523376" y="3243954"/>
                <a:ext cx="7136654" cy="0"/>
              </a:xfrm>
              <a:prstGeom prst="line">
                <a:avLst/>
              </a:prstGeom>
              <a:ln w="3810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2" name="Straight Connector 191"/>
              <p:cNvCxnSpPr/>
              <p:nvPr/>
            </p:nvCxnSpPr>
            <p:spPr>
              <a:xfrm>
                <a:off x="1535141" y="2757837"/>
                <a:ext cx="0" cy="490594"/>
              </a:xfrm>
              <a:prstGeom prst="line">
                <a:avLst/>
              </a:prstGeom>
              <a:ln w="3810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3" name="Straight Connector 192"/>
              <p:cNvCxnSpPr/>
              <p:nvPr/>
            </p:nvCxnSpPr>
            <p:spPr>
              <a:xfrm>
                <a:off x="8660030" y="2757345"/>
                <a:ext cx="0" cy="490594"/>
              </a:xfrm>
              <a:prstGeom prst="line">
                <a:avLst/>
              </a:prstGeom>
              <a:ln w="3810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90" name="Straight Connector 189"/>
            <p:cNvCxnSpPr/>
            <p:nvPr/>
          </p:nvCxnSpPr>
          <p:spPr>
            <a:xfrm>
              <a:off x="5143540" y="1900892"/>
              <a:ext cx="0" cy="1203248"/>
            </a:xfrm>
            <a:prstGeom prst="line">
              <a:avLst/>
            </a:prstGeom>
            <a:ln w="3810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4" name="Group 193"/>
          <p:cNvGrpSpPr/>
          <p:nvPr/>
        </p:nvGrpSpPr>
        <p:grpSpPr>
          <a:xfrm>
            <a:off x="3030205" y="2813631"/>
            <a:ext cx="7079617" cy="520986"/>
            <a:chOff x="2084768" y="1899685"/>
            <a:chExt cx="6113401" cy="1204455"/>
          </a:xfrm>
        </p:grpSpPr>
        <p:grpSp>
          <p:nvGrpSpPr>
            <p:cNvPr id="195" name="Group 194"/>
            <p:cNvGrpSpPr/>
            <p:nvPr/>
          </p:nvGrpSpPr>
          <p:grpSpPr>
            <a:xfrm>
              <a:off x="2084768" y="1899685"/>
              <a:ext cx="6113401" cy="1204455"/>
              <a:chOff x="1523376" y="2757345"/>
              <a:chExt cx="7136654" cy="491086"/>
            </a:xfrm>
          </p:grpSpPr>
          <p:cxnSp>
            <p:nvCxnSpPr>
              <p:cNvPr id="197" name="Straight Connector 196"/>
              <p:cNvCxnSpPr/>
              <p:nvPr/>
            </p:nvCxnSpPr>
            <p:spPr>
              <a:xfrm>
                <a:off x="1523376" y="3243954"/>
                <a:ext cx="7136654" cy="0"/>
              </a:xfrm>
              <a:prstGeom prst="line">
                <a:avLst/>
              </a:prstGeom>
              <a:ln w="381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8" name="Straight Connector 197"/>
              <p:cNvCxnSpPr/>
              <p:nvPr/>
            </p:nvCxnSpPr>
            <p:spPr>
              <a:xfrm>
                <a:off x="1535141" y="2757837"/>
                <a:ext cx="0" cy="490594"/>
              </a:xfrm>
              <a:prstGeom prst="line">
                <a:avLst/>
              </a:prstGeom>
              <a:ln w="381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9" name="Straight Connector 198"/>
              <p:cNvCxnSpPr/>
              <p:nvPr/>
            </p:nvCxnSpPr>
            <p:spPr>
              <a:xfrm>
                <a:off x="8660030" y="2757345"/>
                <a:ext cx="0" cy="490594"/>
              </a:xfrm>
              <a:prstGeom prst="line">
                <a:avLst/>
              </a:prstGeom>
              <a:ln w="381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96" name="Straight Connector 195"/>
            <p:cNvCxnSpPr/>
            <p:nvPr/>
          </p:nvCxnSpPr>
          <p:spPr>
            <a:xfrm>
              <a:off x="5159990" y="1900892"/>
              <a:ext cx="0" cy="1203248"/>
            </a:xfrm>
            <a:prstGeom prst="line">
              <a:avLst/>
            </a:prstGeom>
            <a:ln w="3810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0" name="Group 199"/>
          <p:cNvGrpSpPr/>
          <p:nvPr/>
        </p:nvGrpSpPr>
        <p:grpSpPr>
          <a:xfrm>
            <a:off x="2146735" y="2810423"/>
            <a:ext cx="7159794" cy="673151"/>
            <a:chOff x="2084768" y="1899685"/>
            <a:chExt cx="6113401" cy="1204455"/>
          </a:xfrm>
        </p:grpSpPr>
        <p:grpSp>
          <p:nvGrpSpPr>
            <p:cNvPr id="201" name="Group 200"/>
            <p:cNvGrpSpPr/>
            <p:nvPr/>
          </p:nvGrpSpPr>
          <p:grpSpPr>
            <a:xfrm>
              <a:off x="2084768" y="1899685"/>
              <a:ext cx="6113401" cy="1204455"/>
              <a:chOff x="1523376" y="2757345"/>
              <a:chExt cx="7136654" cy="491086"/>
            </a:xfrm>
          </p:grpSpPr>
          <p:cxnSp>
            <p:nvCxnSpPr>
              <p:cNvPr id="203" name="Straight Connector 202"/>
              <p:cNvCxnSpPr/>
              <p:nvPr/>
            </p:nvCxnSpPr>
            <p:spPr>
              <a:xfrm>
                <a:off x="1523376" y="3243954"/>
                <a:ext cx="7136654" cy="0"/>
              </a:xfrm>
              <a:prstGeom prst="line">
                <a:avLst/>
              </a:prstGeom>
              <a:ln w="38100"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4" name="Straight Connector 203"/>
              <p:cNvCxnSpPr/>
              <p:nvPr/>
            </p:nvCxnSpPr>
            <p:spPr>
              <a:xfrm>
                <a:off x="1535141" y="2757837"/>
                <a:ext cx="0" cy="490594"/>
              </a:xfrm>
              <a:prstGeom prst="line">
                <a:avLst/>
              </a:prstGeom>
              <a:ln w="38100"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5" name="Straight Connector 204"/>
              <p:cNvCxnSpPr/>
              <p:nvPr/>
            </p:nvCxnSpPr>
            <p:spPr>
              <a:xfrm>
                <a:off x="8660030" y="2757345"/>
                <a:ext cx="0" cy="490594"/>
              </a:xfrm>
              <a:prstGeom prst="line">
                <a:avLst/>
              </a:prstGeom>
              <a:ln w="38100"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02" name="Straight Connector 201"/>
            <p:cNvCxnSpPr/>
            <p:nvPr/>
          </p:nvCxnSpPr>
          <p:spPr>
            <a:xfrm>
              <a:off x="5143540" y="1900892"/>
              <a:ext cx="0" cy="1203248"/>
            </a:xfrm>
            <a:prstGeom prst="line">
              <a:avLst/>
            </a:prstGeom>
            <a:ln w="38100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6" name="Group 205"/>
          <p:cNvGrpSpPr/>
          <p:nvPr/>
        </p:nvGrpSpPr>
        <p:grpSpPr>
          <a:xfrm>
            <a:off x="3901956" y="2820485"/>
            <a:ext cx="7079617" cy="373127"/>
            <a:chOff x="2084768" y="1899685"/>
            <a:chExt cx="6113401" cy="1204455"/>
          </a:xfrm>
        </p:grpSpPr>
        <p:grpSp>
          <p:nvGrpSpPr>
            <p:cNvPr id="207" name="Group 206"/>
            <p:cNvGrpSpPr/>
            <p:nvPr/>
          </p:nvGrpSpPr>
          <p:grpSpPr>
            <a:xfrm>
              <a:off x="2084768" y="1899685"/>
              <a:ext cx="6113401" cy="1204455"/>
              <a:chOff x="1523376" y="2757345"/>
              <a:chExt cx="7136654" cy="491086"/>
            </a:xfrm>
          </p:grpSpPr>
          <p:cxnSp>
            <p:nvCxnSpPr>
              <p:cNvPr id="209" name="Straight Connector 208"/>
              <p:cNvCxnSpPr/>
              <p:nvPr/>
            </p:nvCxnSpPr>
            <p:spPr>
              <a:xfrm>
                <a:off x="1523376" y="3243954"/>
                <a:ext cx="7136654" cy="0"/>
              </a:xfrm>
              <a:prstGeom prst="line">
                <a:avLst/>
              </a:prstGeom>
              <a:ln w="38100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0" name="Straight Connector 209"/>
              <p:cNvCxnSpPr/>
              <p:nvPr/>
            </p:nvCxnSpPr>
            <p:spPr>
              <a:xfrm>
                <a:off x="1535141" y="2757837"/>
                <a:ext cx="0" cy="490594"/>
              </a:xfrm>
              <a:prstGeom prst="line">
                <a:avLst/>
              </a:prstGeom>
              <a:ln w="38100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1" name="Straight Connector 210"/>
              <p:cNvCxnSpPr/>
              <p:nvPr/>
            </p:nvCxnSpPr>
            <p:spPr>
              <a:xfrm>
                <a:off x="8660030" y="2757345"/>
                <a:ext cx="0" cy="490594"/>
              </a:xfrm>
              <a:prstGeom prst="line">
                <a:avLst/>
              </a:prstGeom>
              <a:ln w="38100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08" name="Straight Connector 207"/>
            <p:cNvCxnSpPr/>
            <p:nvPr/>
          </p:nvCxnSpPr>
          <p:spPr>
            <a:xfrm>
              <a:off x="5143540" y="1900892"/>
              <a:ext cx="0" cy="1203248"/>
            </a:xfrm>
            <a:prstGeom prst="line">
              <a:avLst/>
            </a:prstGeom>
            <a:ln w="3810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12" name="Straight Arrow Connector 211"/>
          <p:cNvCxnSpPr/>
          <p:nvPr/>
        </p:nvCxnSpPr>
        <p:spPr>
          <a:xfrm>
            <a:off x="2708852" y="3620271"/>
            <a:ext cx="0" cy="500977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3" name="TextBox 212"/>
          <p:cNvSpPr txBox="1"/>
          <p:nvPr/>
        </p:nvSpPr>
        <p:spPr>
          <a:xfrm>
            <a:off x="1947318" y="4156087"/>
            <a:ext cx="1533275" cy="923330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MPRO</a:t>
            </a:r>
          </a:p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3 replicates)</a:t>
            </a:r>
          </a:p>
          <a:p>
            <a:pPr algn="ctr"/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4" name="Straight Arrow Connector 213"/>
          <p:cNvCxnSpPr/>
          <p:nvPr/>
        </p:nvCxnSpPr>
        <p:spPr>
          <a:xfrm>
            <a:off x="4880211" y="3483574"/>
            <a:ext cx="0" cy="637674"/>
          </a:xfrm>
          <a:prstGeom prst="straightConnector1">
            <a:avLst/>
          </a:prstGeom>
          <a:ln w="38100">
            <a:solidFill>
              <a:srgbClr val="92D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Straight Arrow Connector 214"/>
          <p:cNvCxnSpPr/>
          <p:nvPr/>
        </p:nvCxnSpPr>
        <p:spPr>
          <a:xfrm>
            <a:off x="7095690" y="3329867"/>
            <a:ext cx="0" cy="791381"/>
          </a:xfrm>
          <a:prstGeom prst="straightConnector1">
            <a:avLst/>
          </a:prstGeom>
          <a:ln w="38100"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Straight Arrow Connector 215"/>
          <p:cNvCxnSpPr/>
          <p:nvPr/>
        </p:nvCxnSpPr>
        <p:spPr>
          <a:xfrm>
            <a:off x="9301945" y="3190210"/>
            <a:ext cx="0" cy="931038"/>
          </a:xfrm>
          <a:prstGeom prst="straightConnector1">
            <a:avLst/>
          </a:prstGeom>
          <a:ln w="3810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7" name="TextBox 216"/>
          <p:cNvSpPr txBox="1"/>
          <p:nvPr/>
        </p:nvSpPr>
        <p:spPr>
          <a:xfrm>
            <a:off x="8612199" y="4156085"/>
            <a:ext cx="1533275" cy="923330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RCHL</a:t>
            </a:r>
          </a:p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3 replicates)</a:t>
            </a:r>
          </a:p>
          <a:p>
            <a:pPr algn="ctr"/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TextBox 217"/>
          <p:cNvSpPr txBox="1"/>
          <p:nvPr/>
        </p:nvSpPr>
        <p:spPr>
          <a:xfrm>
            <a:off x="6390572" y="4161176"/>
            <a:ext cx="1533275" cy="92333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</a:t>
            </a:r>
          </a:p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3 replicates)</a:t>
            </a:r>
          </a:p>
          <a:p>
            <a:pPr algn="ctr"/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TextBox 218"/>
          <p:cNvSpPr txBox="1"/>
          <p:nvPr/>
        </p:nvSpPr>
        <p:spPr>
          <a:xfrm>
            <a:off x="4168945" y="4156086"/>
            <a:ext cx="1533275" cy="923330"/>
          </a:xfrm>
          <a:prstGeom prst="rect">
            <a:avLst/>
          </a:prstGeom>
          <a:solidFill>
            <a:srgbClr val="92D050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MCHL</a:t>
            </a:r>
          </a:p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3 replicates)</a:t>
            </a:r>
          </a:p>
          <a:p>
            <a:pPr algn="ctr"/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Flowchart: Delay 219"/>
          <p:cNvSpPr/>
          <p:nvPr/>
        </p:nvSpPr>
        <p:spPr>
          <a:xfrm rot="5400000">
            <a:off x="2824461" y="4834059"/>
            <a:ext cx="272213" cy="143407"/>
          </a:xfrm>
          <a:prstGeom prst="flowChartDelay">
            <a:avLst/>
          </a:prstGeom>
          <a:gradFill>
            <a:gsLst>
              <a:gs pos="68000">
                <a:schemeClr val="tx1">
                  <a:lumMod val="50000"/>
                  <a:lumOff val="50000"/>
                </a:schemeClr>
              </a:gs>
              <a:gs pos="66000">
                <a:schemeClr val="bg1"/>
              </a:gs>
              <a:gs pos="98000">
                <a:schemeClr val="tx1">
                  <a:lumMod val="50000"/>
                  <a:lumOff val="50000"/>
                </a:schemeClr>
              </a:gs>
            </a:gsLst>
            <a:lin ang="0" scaled="1"/>
          </a:gra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Flowchart: Delay 220"/>
          <p:cNvSpPr/>
          <p:nvPr/>
        </p:nvSpPr>
        <p:spPr>
          <a:xfrm rot="5400000">
            <a:off x="2554324" y="4834059"/>
            <a:ext cx="272213" cy="143407"/>
          </a:xfrm>
          <a:prstGeom prst="flowChartDelay">
            <a:avLst/>
          </a:prstGeom>
          <a:gradFill>
            <a:gsLst>
              <a:gs pos="68000">
                <a:schemeClr val="tx1">
                  <a:lumMod val="50000"/>
                  <a:lumOff val="50000"/>
                </a:schemeClr>
              </a:gs>
              <a:gs pos="66000">
                <a:schemeClr val="bg1"/>
              </a:gs>
              <a:gs pos="98000">
                <a:schemeClr val="tx1">
                  <a:lumMod val="50000"/>
                  <a:lumOff val="50000"/>
                </a:schemeClr>
              </a:gs>
            </a:gsLst>
            <a:lin ang="0" scaled="1"/>
          </a:gra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Flowchart: Delay 221"/>
          <p:cNvSpPr/>
          <p:nvPr/>
        </p:nvSpPr>
        <p:spPr>
          <a:xfrm rot="5400000">
            <a:off x="2282227" y="4834059"/>
            <a:ext cx="272213" cy="143407"/>
          </a:xfrm>
          <a:prstGeom prst="flowChartDelay">
            <a:avLst/>
          </a:prstGeom>
          <a:gradFill>
            <a:gsLst>
              <a:gs pos="68000">
                <a:schemeClr val="tx1">
                  <a:lumMod val="50000"/>
                  <a:lumOff val="50000"/>
                </a:schemeClr>
              </a:gs>
              <a:gs pos="66000">
                <a:schemeClr val="bg1"/>
              </a:gs>
              <a:gs pos="98000">
                <a:schemeClr val="tx1">
                  <a:lumMod val="50000"/>
                  <a:lumOff val="50000"/>
                </a:schemeClr>
              </a:gs>
            </a:gsLst>
            <a:lin ang="0" scaled="1"/>
          </a:gra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6" name="Group 225"/>
          <p:cNvGrpSpPr/>
          <p:nvPr/>
        </p:nvGrpSpPr>
        <p:grpSpPr>
          <a:xfrm>
            <a:off x="4576273" y="4769655"/>
            <a:ext cx="758839" cy="272213"/>
            <a:chOff x="3120911" y="5549753"/>
            <a:chExt cx="668584" cy="272213"/>
          </a:xfrm>
        </p:grpSpPr>
        <p:sp>
          <p:nvSpPr>
            <p:cNvPr id="223" name="Flowchart: Delay 222"/>
            <p:cNvSpPr/>
            <p:nvPr/>
          </p:nvSpPr>
          <p:spPr>
            <a:xfrm rot="5400000">
              <a:off x="3590213" y="5622685"/>
              <a:ext cx="272213" cy="126350"/>
            </a:xfrm>
            <a:prstGeom prst="flowChartDelay">
              <a:avLst/>
            </a:prstGeom>
            <a:gradFill>
              <a:gsLst>
                <a:gs pos="68000">
                  <a:schemeClr val="tx1">
                    <a:lumMod val="50000"/>
                    <a:lumOff val="50000"/>
                  </a:schemeClr>
                </a:gs>
                <a:gs pos="66000">
                  <a:schemeClr val="bg1"/>
                </a:gs>
                <a:gs pos="98000">
                  <a:schemeClr val="tx1">
                    <a:lumMod val="50000"/>
                    <a:lumOff val="50000"/>
                  </a:schemeClr>
                </a:gs>
              </a:gsLst>
              <a:lin ang="0" scaled="1"/>
            </a:gradFill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4" name="Flowchart: Delay 223"/>
            <p:cNvSpPr/>
            <p:nvPr/>
          </p:nvSpPr>
          <p:spPr>
            <a:xfrm rot="5400000">
              <a:off x="3320076" y="5622685"/>
              <a:ext cx="272213" cy="126350"/>
            </a:xfrm>
            <a:prstGeom prst="flowChartDelay">
              <a:avLst/>
            </a:prstGeom>
            <a:gradFill>
              <a:gsLst>
                <a:gs pos="68000">
                  <a:schemeClr val="tx1">
                    <a:lumMod val="50000"/>
                    <a:lumOff val="50000"/>
                  </a:schemeClr>
                </a:gs>
                <a:gs pos="66000">
                  <a:schemeClr val="bg1"/>
                </a:gs>
                <a:gs pos="98000">
                  <a:schemeClr val="tx1">
                    <a:lumMod val="50000"/>
                    <a:lumOff val="50000"/>
                  </a:schemeClr>
                </a:gs>
              </a:gsLst>
              <a:lin ang="0" scaled="1"/>
            </a:gradFill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Flowchart: Delay 224"/>
            <p:cNvSpPr/>
            <p:nvPr/>
          </p:nvSpPr>
          <p:spPr>
            <a:xfrm rot="5400000">
              <a:off x="3047979" y="5622685"/>
              <a:ext cx="272213" cy="126350"/>
            </a:xfrm>
            <a:prstGeom prst="flowChartDelay">
              <a:avLst/>
            </a:prstGeom>
            <a:gradFill>
              <a:gsLst>
                <a:gs pos="68000">
                  <a:schemeClr val="tx1">
                    <a:lumMod val="50000"/>
                    <a:lumOff val="50000"/>
                  </a:schemeClr>
                </a:gs>
                <a:gs pos="66000">
                  <a:schemeClr val="bg1"/>
                </a:gs>
                <a:gs pos="98000">
                  <a:schemeClr val="tx1">
                    <a:lumMod val="50000"/>
                    <a:lumOff val="50000"/>
                  </a:schemeClr>
                </a:gs>
              </a:gsLst>
              <a:lin ang="0" scaled="1"/>
            </a:gradFill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7" name="Flowchart: Delay 226"/>
          <p:cNvSpPr/>
          <p:nvPr/>
        </p:nvSpPr>
        <p:spPr>
          <a:xfrm rot="5400000">
            <a:off x="7270194" y="4834061"/>
            <a:ext cx="272213" cy="143407"/>
          </a:xfrm>
          <a:prstGeom prst="flowChartDelay">
            <a:avLst/>
          </a:prstGeom>
          <a:gradFill>
            <a:gsLst>
              <a:gs pos="68000">
                <a:schemeClr val="tx1">
                  <a:lumMod val="50000"/>
                  <a:lumOff val="50000"/>
                </a:schemeClr>
              </a:gs>
              <a:gs pos="66000">
                <a:schemeClr val="bg1"/>
              </a:gs>
              <a:gs pos="98000">
                <a:schemeClr val="tx1">
                  <a:lumMod val="50000"/>
                  <a:lumOff val="50000"/>
                </a:schemeClr>
              </a:gs>
            </a:gsLst>
            <a:lin ang="0" scaled="1"/>
          </a:gra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Flowchart: Delay 227"/>
          <p:cNvSpPr/>
          <p:nvPr/>
        </p:nvSpPr>
        <p:spPr>
          <a:xfrm rot="5400000">
            <a:off x="7000057" y="4834061"/>
            <a:ext cx="272213" cy="143407"/>
          </a:xfrm>
          <a:prstGeom prst="flowChartDelay">
            <a:avLst/>
          </a:prstGeom>
          <a:gradFill>
            <a:gsLst>
              <a:gs pos="68000">
                <a:schemeClr val="tx1">
                  <a:lumMod val="50000"/>
                  <a:lumOff val="50000"/>
                </a:schemeClr>
              </a:gs>
              <a:gs pos="66000">
                <a:schemeClr val="bg1"/>
              </a:gs>
              <a:gs pos="98000">
                <a:schemeClr val="tx1">
                  <a:lumMod val="50000"/>
                  <a:lumOff val="50000"/>
                </a:schemeClr>
              </a:gs>
            </a:gsLst>
            <a:lin ang="0" scaled="1"/>
          </a:gra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Flowchart: Delay 228"/>
          <p:cNvSpPr/>
          <p:nvPr/>
        </p:nvSpPr>
        <p:spPr>
          <a:xfrm rot="5400000">
            <a:off x="6727960" y="4834061"/>
            <a:ext cx="272213" cy="143407"/>
          </a:xfrm>
          <a:prstGeom prst="flowChartDelay">
            <a:avLst/>
          </a:prstGeom>
          <a:gradFill>
            <a:gsLst>
              <a:gs pos="68000">
                <a:schemeClr val="tx1">
                  <a:lumMod val="50000"/>
                  <a:lumOff val="50000"/>
                </a:schemeClr>
              </a:gs>
              <a:gs pos="66000">
                <a:schemeClr val="bg1"/>
              </a:gs>
              <a:gs pos="98000">
                <a:schemeClr val="tx1">
                  <a:lumMod val="50000"/>
                  <a:lumOff val="50000"/>
                </a:schemeClr>
              </a:gs>
            </a:gsLst>
            <a:lin ang="0" scaled="1"/>
          </a:gra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Flowchart: Delay 229"/>
          <p:cNvSpPr/>
          <p:nvPr/>
        </p:nvSpPr>
        <p:spPr>
          <a:xfrm rot="5400000">
            <a:off x="9537539" y="4834059"/>
            <a:ext cx="272213" cy="143407"/>
          </a:xfrm>
          <a:prstGeom prst="flowChartDelay">
            <a:avLst/>
          </a:prstGeom>
          <a:gradFill>
            <a:gsLst>
              <a:gs pos="68000">
                <a:schemeClr val="tx1">
                  <a:lumMod val="50000"/>
                  <a:lumOff val="50000"/>
                </a:schemeClr>
              </a:gs>
              <a:gs pos="66000">
                <a:schemeClr val="bg1"/>
              </a:gs>
              <a:gs pos="98000">
                <a:schemeClr val="tx1">
                  <a:lumMod val="50000"/>
                  <a:lumOff val="50000"/>
                </a:schemeClr>
              </a:gs>
            </a:gsLst>
            <a:lin ang="0" scaled="1"/>
          </a:gra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Flowchart: Delay 230"/>
          <p:cNvSpPr/>
          <p:nvPr/>
        </p:nvSpPr>
        <p:spPr>
          <a:xfrm rot="5400000">
            <a:off x="9267402" y="4834059"/>
            <a:ext cx="272213" cy="143407"/>
          </a:xfrm>
          <a:prstGeom prst="flowChartDelay">
            <a:avLst/>
          </a:prstGeom>
          <a:gradFill>
            <a:gsLst>
              <a:gs pos="68000">
                <a:schemeClr val="tx1">
                  <a:lumMod val="50000"/>
                  <a:lumOff val="50000"/>
                </a:schemeClr>
              </a:gs>
              <a:gs pos="66000">
                <a:schemeClr val="bg1"/>
              </a:gs>
              <a:gs pos="98000">
                <a:schemeClr val="tx1">
                  <a:lumMod val="50000"/>
                  <a:lumOff val="50000"/>
                </a:schemeClr>
              </a:gs>
            </a:gsLst>
            <a:lin ang="0" scaled="1"/>
          </a:gra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Flowchart: Delay 231"/>
          <p:cNvSpPr/>
          <p:nvPr/>
        </p:nvSpPr>
        <p:spPr>
          <a:xfrm rot="5400000">
            <a:off x="8995305" y="4834059"/>
            <a:ext cx="272213" cy="143407"/>
          </a:xfrm>
          <a:prstGeom prst="flowChartDelay">
            <a:avLst/>
          </a:prstGeom>
          <a:gradFill>
            <a:gsLst>
              <a:gs pos="68000">
                <a:schemeClr val="tx1">
                  <a:lumMod val="50000"/>
                  <a:lumOff val="50000"/>
                </a:schemeClr>
              </a:gs>
              <a:gs pos="66000">
                <a:schemeClr val="bg1"/>
              </a:gs>
              <a:gs pos="98000">
                <a:schemeClr val="tx1">
                  <a:lumMod val="50000"/>
                  <a:lumOff val="50000"/>
                </a:schemeClr>
              </a:gs>
            </a:gsLst>
            <a:lin ang="0" scaled="1"/>
          </a:gra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6874126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43</TotalTime>
  <Words>41</Words>
  <Application>Microsoft Office PowerPoint</Application>
  <PresentationFormat>自定义</PresentationFormat>
  <Paragraphs>38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Theme</vt:lpstr>
      <vt:lpstr>幻灯片 1</vt:lpstr>
      <vt:lpstr>幻灯片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Administrator</cp:lastModifiedBy>
  <cp:revision>50</cp:revision>
  <dcterms:created xsi:type="dcterms:W3CDTF">2016-12-27T13:25:44Z</dcterms:created>
  <dcterms:modified xsi:type="dcterms:W3CDTF">2018-02-01T10:59:58Z</dcterms:modified>
</cp:coreProperties>
</file>